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10"/>
  </p:notesMasterIdLst>
  <p:sldIdLst>
    <p:sldId id="351" r:id="rId2"/>
    <p:sldId id="372" r:id="rId3"/>
    <p:sldId id="376" r:id="rId4"/>
    <p:sldId id="391" r:id="rId5"/>
    <p:sldId id="389" r:id="rId6"/>
    <p:sldId id="381" r:id="rId7"/>
    <p:sldId id="374" r:id="rId8"/>
    <p:sldId id="390" r:id="rId9"/>
  </p:sldIdLst>
  <p:sldSz cx="18000663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0000"/>
    <a:srgbClr val="00C000"/>
    <a:srgbClr val="339966"/>
    <a:srgbClr val="3366F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87635" autoAdjust="0"/>
  </p:normalViewPr>
  <p:slideViewPr>
    <p:cSldViewPr snapToGrid="0">
      <p:cViewPr varScale="1">
        <p:scale>
          <a:sx n="61" d="100"/>
          <a:sy n="61" d="100"/>
        </p:scale>
        <p:origin x="1404" y="102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00" d="100"/>
        <a:sy n="100" d="100"/>
      </p:scale>
      <p:origin x="0" y="-420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\R_Behcet\Revision\Reviewer_2\Results_DC_B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\R_Behcet\Revision\Reviewer_2\Results_DC_B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Plasm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M$14</c:f>
              <c:strCache>
                <c:ptCount val="1"/>
                <c:pt idx="0">
                  <c:v>R2</c:v>
                </c:pt>
              </c:strCache>
            </c:strRef>
          </c:tx>
          <c:spPr>
            <a:solidFill>
              <a:srgbClr val="0000CC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L$15:$L$22</c:f>
              <c:strCache>
                <c:ptCount val="8"/>
                <c:pt idx="0">
                  <c:v>Oral aphthous ulcers</c:v>
                </c:pt>
                <c:pt idx="1">
                  <c:v>Genital ulcers</c:v>
                </c:pt>
                <c:pt idx="2">
                  <c:v>Skin lesions</c:v>
                </c:pt>
                <c:pt idx="3">
                  <c:v>Uveitis</c:v>
                </c:pt>
                <c:pt idx="4">
                  <c:v>Arthritis</c:v>
                </c:pt>
                <c:pt idx="5">
                  <c:v>Vascular involvement</c:v>
                </c:pt>
                <c:pt idx="6">
                  <c:v>Positive pathergy</c:v>
                </c:pt>
                <c:pt idx="7">
                  <c:v>HLA-B51 </c:v>
                </c:pt>
              </c:strCache>
            </c:strRef>
          </c:cat>
          <c:val>
            <c:numRef>
              <c:f>Sheet2!$M$15:$M$22</c:f>
              <c:numCache>
                <c:formatCode>0.000</c:formatCode>
                <c:ptCount val="8"/>
                <c:pt idx="0">
                  <c:v>1.9613732029551099E-2</c:v>
                </c:pt>
                <c:pt idx="1">
                  <c:v>3.4120983345636902E-2</c:v>
                </c:pt>
                <c:pt idx="2">
                  <c:v>1.8217032536782501E-2</c:v>
                </c:pt>
                <c:pt idx="3">
                  <c:v>1.3041308434708901E-2</c:v>
                </c:pt>
                <c:pt idx="4">
                  <c:v>1.9634492818161701E-2</c:v>
                </c:pt>
                <c:pt idx="5">
                  <c:v>1.35228759232648E-2</c:v>
                </c:pt>
                <c:pt idx="6">
                  <c:v>1.9681079561947801E-2</c:v>
                </c:pt>
                <c:pt idx="7">
                  <c:v>1.85632072244941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96-4DC3-9AEB-941AA34D96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8978976"/>
        <c:axId val="1178983136"/>
      </c:barChart>
      <c:catAx>
        <c:axId val="1178978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linical phenotype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178983136"/>
        <c:crosses val="autoZero"/>
        <c:auto val="1"/>
        <c:lblAlgn val="ctr"/>
        <c:lblOffset val="100"/>
        <c:noMultiLvlLbl val="0"/>
      </c:catAx>
      <c:valAx>
        <c:axId val="11789831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2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0.0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178978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PBM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P$14</c:f>
              <c:strCache>
                <c:ptCount val="1"/>
                <c:pt idx="0">
                  <c:v>R2</c:v>
                </c:pt>
              </c:strCache>
            </c:strRef>
          </c:tx>
          <c:spPr>
            <a:solidFill>
              <a:srgbClr val="0000CC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O$15:$O$22</c:f>
              <c:strCache>
                <c:ptCount val="8"/>
                <c:pt idx="0">
                  <c:v>Oral aphthous ulcers</c:v>
                </c:pt>
                <c:pt idx="1">
                  <c:v>Genital ulcers</c:v>
                </c:pt>
                <c:pt idx="2">
                  <c:v>Skin lesions</c:v>
                </c:pt>
                <c:pt idx="3">
                  <c:v>Uveitis</c:v>
                </c:pt>
                <c:pt idx="4">
                  <c:v>Vascular involvement</c:v>
                </c:pt>
                <c:pt idx="5">
                  <c:v>Positive pathergy</c:v>
                </c:pt>
                <c:pt idx="6">
                  <c:v>Positive ANA</c:v>
                </c:pt>
                <c:pt idx="7">
                  <c:v>HLA-B51 </c:v>
                </c:pt>
              </c:strCache>
            </c:strRef>
          </c:cat>
          <c:val>
            <c:numRef>
              <c:f>Sheet2!$P$15:$P$22</c:f>
              <c:numCache>
                <c:formatCode>0.000</c:formatCode>
                <c:ptCount val="8"/>
                <c:pt idx="0">
                  <c:v>2.3155412580633101E-2</c:v>
                </c:pt>
                <c:pt idx="1">
                  <c:v>3.3620038303318597E-2</c:v>
                </c:pt>
                <c:pt idx="2">
                  <c:v>1.74195182083767E-2</c:v>
                </c:pt>
                <c:pt idx="3">
                  <c:v>1.1774039992704301E-2</c:v>
                </c:pt>
                <c:pt idx="4">
                  <c:v>1.4090816869006401E-2</c:v>
                </c:pt>
                <c:pt idx="5">
                  <c:v>2.3646365740524901E-2</c:v>
                </c:pt>
                <c:pt idx="6">
                  <c:v>3.8996818977933903E-2</c:v>
                </c:pt>
                <c:pt idx="7">
                  <c:v>1.9647516295281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05-41AC-AA36-61D9484FC5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71358672"/>
        <c:axId val="1471361584"/>
      </c:barChart>
      <c:catAx>
        <c:axId val="14713586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linical phenotype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471361584"/>
        <c:crosses val="autoZero"/>
        <c:auto val="1"/>
        <c:lblAlgn val="ctr"/>
        <c:lblOffset val="100"/>
        <c:noMultiLvlLbl val="0"/>
      </c:catAx>
      <c:valAx>
        <c:axId val="1471361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ko-KR"/>
                  <a:t> </a:t>
                </a:r>
                <a:r>
                  <a:rPr lang="en-US"/>
                  <a:t>R2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0.0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471358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39BC9E-9028-40B9-9DA1-A507C563B5AA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23963" y="1143000"/>
            <a:ext cx="4410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791180-9B35-4AF8-8176-9F24072507A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8398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1pPr>
    <a:lvl2pPr marL="604784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2pPr>
    <a:lvl3pPr marL="1209568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3pPr>
    <a:lvl4pPr marL="1814352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4pPr>
    <a:lvl5pPr marL="2419137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5pPr>
    <a:lvl6pPr marL="3023921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6pPr>
    <a:lvl7pPr marL="3628705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7pPr>
    <a:lvl8pPr marL="4233489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8pPr>
    <a:lvl9pPr marL="4838273" algn="l" defTabSz="1209568" rtl="0" eaLnBrk="1" latinLnBrk="1" hangingPunct="1">
      <a:defRPr sz="158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0956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(A) Sex, colchicine, salazopyrine, and pentoxyphylline are significantly different according to groups (Fisher’s exact test, p&lt;0.05) (B) Score scatter plot of principal component analysis (PCA). The results suggested that there was no cluster according to potential confounders.</a:t>
            </a:r>
          </a:p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791180-9B35-4AF8-8176-9F24072507A4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71285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0956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60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ed and blue indicate the metabolites that are significantly up- or down-regulated in BD (Mann-Whitney test, p&lt;0.05)</a:t>
            </a:r>
          </a:p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791180-9B35-4AF8-8176-9F24072507A4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729942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0956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40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ed and blue indicate the metabolites that are significantly up- or down-regulated in BD (Mann-Whitney test, p&lt;0.05)</a:t>
            </a:r>
          </a:p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791180-9B35-4AF8-8176-9F24072507A4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97107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0956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p-value was calculated using Mann-Whitneytest and Dunn test with benjamini hochberg correction.</a:t>
            </a:r>
          </a:p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791180-9B35-4AF8-8176-9F24072507A4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92863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0956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400">
                <a:latin typeface="Arial" panose="020B0604020202020204" pitchFamily="34" charset="0"/>
                <a:cs typeface="Arial" panose="020B0604020202020204" pitchFamily="34" charset="0"/>
              </a:rPr>
              <a:t>p-value was calculated using Mann-Whitneytest and Dunn test with benjamini hochberg correction.</a:t>
            </a:r>
          </a:p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791180-9B35-4AF8-8176-9F24072507A4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936505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0956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p-value was calculated using Mann-Whitneytest.</a:t>
            </a:r>
            <a:endParaRPr lang="ko-KR" altLang="en-US"/>
          </a:p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791180-9B35-4AF8-8176-9F24072507A4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28737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062083"/>
            <a:ext cx="15300564" cy="4386662"/>
          </a:xfrm>
        </p:spPr>
        <p:txBody>
          <a:bodyPr anchor="b"/>
          <a:lstStyle>
            <a:lvl1pPr algn="ctr">
              <a:defRPr sz="1102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6617911"/>
            <a:ext cx="13500497" cy="3042080"/>
          </a:xfrm>
        </p:spPr>
        <p:txBody>
          <a:bodyPr/>
          <a:lstStyle>
            <a:lvl1pPr marL="0" indent="0" algn="ctr">
              <a:buNone/>
              <a:defRPr sz="4410"/>
            </a:lvl1pPr>
            <a:lvl2pPr marL="840014" indent="0" algn="ctr">
              <a:buNone/>
              <a:defRPr sz="3675"/>
            </a:lvl2pPr>
            <a:lvl3pPr marL="1680027" indent="0" algn="ctr">
              <a:buNone/>
              <a:defRPr sz="3307"/>
            </a:lvl3pPr>
            <a:lvl4pPr marL="2520041" indent="0" algn="ctr">
              <a:buNone/>
              <a:defRPr sz="2940"/>
            </a:lvl4pPr>
            <a:lvl5pPr marL="3360054" indent="0" algn="ctr">
              <a:buNone/>
              <a:defRPr sz="2940"/>
            </a:lvl5pPr>
            <a:lvl6pPr marL="4200068" indent="0" algn="ctr">
              <a:buNone/>
              <a:defRPr sz="2940"/>
            </a:lvl6pPr>
            <a:lvl7pPr marL="5040081" indent="0" algn="ctr">
              <a:buNone/>
              <a:defRPr sz="2940"/>
            </a:lvl7pPr>
            <a:lvl8pPr marL="5880095" indent="0" algn="ctr">
              <a:buNone/>
              <a:defRPr sz="2940"/>
            </a:lvl8pPr>
            <a:lvl9pPr marL="6720108" indent="0" algn="ctr">
              <a:buNone/>
              <a:defRPr sz="294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7816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1373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670833"/>
            <a:ext cx="3881393" cy="1067790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670833"/>
            <a:ext cx="11419171" cy="1067790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9091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1875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141251"/>
            <a:ext cx="15525572" cy="5241244"/>
          </a:xfrm>
        </p:spPr>
        <p:txBody>
          <a:bodyPr anchor="b"/>
          <a:lstStyle>
            <a:lvl1pPr>
              <a:defRPr sz="1102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8432079"/>
            <a:ext cx="15525572" cy="2756246"/>
          </a:xfrm>
        </p:spPr>
        <p:txBody>
          <a:bodyPr/>
          <a:lstStyle>
            <a:lvl1pPr marL="0" indent="0">
              <a:buNone/>
              <a:defRPr sz="4410">
                <a:solidFill>
                  <a:schemeClr val="tx1"/>
                </a:solidFill>
              </a:defRPr>
            </a:lvl1pPr>
            <a:lvl2pPr marL="840014" indent="0">
              <a:buNone/>
              <a:defRPr sz="3675">
                <a:solidFill>
                  <a:schemeClr val="tx1">
                    <a:tint val="75000"/>
                  </a:schemeClr>
                </a:solidFill>
              </a:defRPr>
            </a:lvl2pPr>
            <a:lvl3pPr marL="1680027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3pPr>
            <a:lvl4pPr marL="2520041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4pPr>
            <a:lvl5pPr marL="3360054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5pPr>
            <a:lvl6pPr marL="420006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6pPr>
            <a:lvl7pPr marL="5040081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7pPr>
            <a:lvl8pPr marL="5880095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8pPr>
            <a:lvl9pPr marL="672010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7685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354163"/>
            <a:ext cx="7650282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354163"/>
            <a:ext cx="7650282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699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670836"/>
            <a:ext cx="15525572" cy="243541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088748"/>
            <a:ext cx="7615123" cy="1513748"/>
          </a:xfrm>
        </p:spPr>
        <p:txBody>
          <a:bodyPr anchor="b"/>
          <a:lstStyle>
            <a:lvl1pPr marL="0" indent="0">
              <a:buNone/>
              <a:defRPr sz="4410" b="1"/>
            </a:lvl1pPr>
            <a:lvl2pPr marL="840014" indent="0">
              <a:buNone/>
              <a:defRPr sz="3675" b="1"/>
            </a:lvl2pPr>
            <a:lvl3pPr marL="1680027" indent="0">
              <a:buNone/>
              <a:defRPr sz="3307" b="1"/>
            </a:lvl3pPr>
            <a:lvl4pPr marL="2520041" indent="0">
              <a:buNone/>
              <a:defRPr sz="2940" b="1"/>
            </a:lvl4pPr>
            <a:lvl5pPr marL="3360054" indent="0">
              <a:buNone/>
              <a:defRPr sz="2940" b="1"/>
            </a:lvl5pPr>
            <a:lvl6pPr marL="4200068" indent="0">
              <a:buNone/>
              <a:defRPr sz="2940" b="1"/>
            </a:lvl6pPr>
            <a:lvl7pPr marL="5040081" indent="0">
              <a:buNone/>
              <a:defRPr sz="2940" b="1"/>
            </a:lvl7pPr>
            <a:lvl8pPr marL="5880095" indent="0">
              <a:buNone/>
              <a:defRPr sz="2940" b="1"/>
            </a:lvl8pPr>
            <a:lvl9pPr marL="6720108" indent="0">
              <a:buNone/>
              <a:defRPr sz="294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4602496"/>
            <a:ext cx="7615123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088748"/>
            <a:ext cx="7652626" cy="1513748"/>
          </a:xfrm>
        </p:spPr>
        <p:txBody>
          <a:bodyPr anchor="b"/>
          <a:lstStyle>
            <a:lvl1pPr marL="0" indent="0">
              <a:buNone/>
              <a:defRPr sz="4410" b="1"/>
            </a:lvl1pPr>
            <a:lvl2pPr marL="840014" indent="0">
              <a:buNone/>
              <a:defRPr sz="3675" b="1"/>
            </a:lvl2pPr>
            <a:lvl3pPr marL="1680027" indent="0">
              <a:buNone/>
              <a:defRPr sz="3307" b="1"/>
            </a:lvl3pPr>
            <a:lvl4pPr marL="2520041" indent="0">
              <a:buNone/>
              <a:defRPr sz="2940" b="1"/>
            </a:lvl4pPr>
            <a:lvl5pPr marL="3360054" indent="0">
              <a:buNone/>
              <a:defRPr sz="2940" b="1"/>
            </a:lvl5pPr>
            <a:lvl6pPr marL="4200068" indent="0">
              <a:buNone/>
              <a:defRPr sz="2940" b="1"/>
            </a:lvl6pPr>
            <a:lvl7pPr marL="5040081" indent="0">
              <a:buNone/>
              <a:defRPr sz="2940" b="1"/>
            </a:lvl7pPr>
            <a:lvl8pPr marL="5880095" indent="0">
              <a:buNone/>
              <a:defRPr sz="2940" b="1"/>
            </a:lvl8pPr>
            <a:lvl9pPr marL="6720108" indent="0">
              <a:buNone/>
              <a:defRPr sz="294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4602496"/>
            <a:ext cx="7652626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2909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6891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7609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839999"/>
            <a:ext cx="5805682" cy="2939997"/>
          </a:xfrm>
        </p:spPr>
        <p:txBody>
          <a:bodyPr anchor="b"/>
          <a:lstStyle>
            <a:lvl1pPr>
              <a:defRPr sz="587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814168"/>
            <a:ext cx="9112836" cy="8954158"/>
          </a:xfrm>
        </p:spPr>
        <p:txBody>
          <a:bodyPr/>
          <a:lstStyle>
            <a:lvl1pPr>
              <a:defRPr sz="5879"/>
            </a:lvl1pPr>
            <a:lvl2pPr>
              <a:defRPr sz="5144"/>
            </a:lvl2pPr>
            <a:lvl3pPr>
              <a:defRPr sz="4410"/>
            </a:lvl3pPr>
            <a:lvl4pPr>
              <a:defRPr sz="3675"/>
            </a:lvl4pPr>
            <a:lvl5pPr>
              <a:defRPr sz="3675"/>
            </a:lvl5pPr>
            <a:lvl6pPr>
              <a:defRPr sz="3675"/>
            </a:lvl6pPr>
            <a:lvl7pPr>
              <a:defRPr sz="3675"/>
            </a:lvl7pPr>
            <a:lvl8pPr>
              <a:defRPr sz="3675"/>
            </a:lvl8pPr>
            <a:lvl9pPr>
              <a:defRPr sz="36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3779996"/>
            <a:ext cx="5805682" cy="7002911"/>
          </a:xfrm>
        </p:spPr>
        <p:txBody>
          <a:bodyPr/>
          <a:lstStyle>
            <a:lvl1pPr marL="0" indent="0">
              <a:buNone/>
              <a:defRPr sz="2940"/>
            </a:lvl1pPr>
            <a:lvl2pPr marL="840014" indent="0">
              <a:buNone/>
              <a:defRPr sz="2572"/>
            </a:lvl2pPr>
            <a:lvl3pPr marL="1680027" indent="0">
              <a:buNone/>
              <a:defRPr sz="2205"/>
            </a:lvl3pPr>
            <a:lvl4pPr marL="2520041" indent="0">
              <a:buNone/>
              <a:defRPr sz="1837"/>
            </a:lvl4pPr>
            <a:lvl5pPr marL="3360054" indent="0">
              <a:buNone/>
              <a:defRPr sz="1837"/>
            </a:lvl5pPr>
            <a:lvl6pPr marL="4200068" indent="0">
              <a:buNone/>
              <a:defRPr sz="1837"/>
            </a:lvl6pPr>
            <a:lvl7pPr marL="5040081" indent="0">
              <a:buNone/>
              <a:defRPr sz="1837"/>
            </a:lvl7pPr>
            <a:lvl8pPr marL="5880095" indent="0">
              <a:buNone/>
              <a:defRPr sz="1837"/>
            </a:lvl8pPr>
            <a:lvl9pPr marL="6720108" indent="0">
              <a:buNone/>
              <a:defRPr sz="183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8309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839999"/>
            <a:ext cx="5805682" cy="2939997"/>
          </a:xfrm>
        </p:spPr>
        <p:txBody>
          <a:bodyPr anchor="b"/>
          <a:lstStyle>
            <a:lvl1pPr>
              <a:defRPr sz="587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814168"/>
            <a:ext cx="9112836" cy="8954158"/>
          </a:xfrm>
        </p:spPr>
        <p:txBody>
          <a:bodyPr anchor="t"/>
          <a:lstStyle>
            <a:lvl1pPr marL="0" indent="0">
              <a:buNone/>
              <a:defRPr sz="5879"/>
            </a:lvl1pPr>
            <a:lvl2pPr marL="840014" indent="0">
              <a:buNone/>
              <a:defRPr sz="5144"/>
            </a:lvl2pPr>
            <a:lvl3pPr marL="1680027" indent="0">
              <a:buNone/>
              <a:defRPr sz="4410"/>
            </a:lvl3pPr>
            <a:lvl4pPr marL="2520041" indent="0">
              <a:buNone/>
              <a:defRPr sz="3675"/>
            </a:lvl4pPr>
            <a:lvl5pPr marL="3360054" indent="0">
              <a:buNone/>
              <a:defRPr sz="3675"/>
            </a:lvl5pPr>
            <a:lvl6pPr marL="4200068" indent="0">
              <a:buNone/>
              <a:defRPr sz="3675"/>
            </a:lvl6pPr>
            <a:lvl7pPr marL="5040081" indent="0">
              <a:buNone/>
              <a:defRPr sz="3675"/>
            </a:lvl7pPr>
            <a:lvl8pPr marL="5880095" indent="0">
              <a:buNone/>
              <a:defRPr sz="3675"/>
            </a:lvl8pPr>
            <a:lvl9pPr marL="6720108" indent="0">
              <a:buNone/>
              <a:defRPr sz="367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3779996"/>
            <a:ext cx="5805682" cy="7002911"/>
          </a:xfrm>
        </p:spPr>
        <p:txBody>
          <a:bodyPr/>
          <a:lstStyle>
            <a:lvl1pPr marL="0" indent="0">
              <a:buNone/>
              <a:defRPr sz="2940"/>
            </a:lvl1pPr>
            <a:lvl2pPr marL="840014" indent="0">
              <a:buNone/>
              <a:defRPr sz="2572"/>
            </a:lvl2pPr>
            <a:lvl3pPr marL="1680027" indent="0">
              <a:buNone/>
              <a:defRPr sz="2205"/>
            </a:lvl3pPr>
            <a:lvl4pPr marL="2520041" indent="0">
              <a:buNone/>
              <a:defRPr sz="1837"/>
            </a:lvl4pPr>
            <a:lvl5pPr marL="3360054" indent="0">
              <a:buNone/>
              <a:defRPr sz="1837"/>
            </a:lvl5pPr>
            <a:lvl6pPr marL="4200068" indent="0">
              <a:buNone/>
              <a:defRPr sz="1837"/>
            </a:lvl6pPr>
            <a:lvl7pPr marL="5040081" indent="0">
              <a:buNone/>
              <a:defRPr sz="1837"/>
            </a:lvl7pPr>
            <a:lvl8pPr marL="5880095" indent="0">
              <a:buNone/>
              <a:defRPr sz="1837"/>
            </a:lvl8pPr>
            <a:lvl9pPr marL="6720108" indent="0">
              <a:buNone/>
              <a:defRPr sz="183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4248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670836"/>
            <a:ext cx="15525572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354163"/>
            <a:ext cx="15525572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1678325"/>
            <a:ext cx="405014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4EE3D1-C285-4084-B294-AAE8B7D00616}" type="datetimeFigureOut">
              <a:rPr lang="ko-KR" altLang="en-US" smtClean="0"/>
              <a:t>2022-1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1678325"/>
            <a:ext cx="6075224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1678325"/>
            <a:ext cx="405014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24F32-EDED-4F58-92E3-FC73E42955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9111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80027" rtl="0" eaLnBrk="1" latinLnBrk="1" hangingPunct="1">
        <a:lnSpc>
          <a:spcPct val="90000"/>
        </a:lnSpc>
        <a:spcBef>
          <a:spcPct val="0"/>
        </a:spcBef>
        <a:buNone/>
        <a:defRPr sz="8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0007" indent="-420007" algn="l" defTabSz="1680027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5144" kern="1200">
          <a:solidFill>
            <a:schemeClr val="tx1"/>
          </a:solidFill>
          <a:latin typeface="+mn-lt"/>
          <a:ea typeface="+mn-ea"/>
          <a:cs typeface="+mn-cs"/>
        </a:defRPr>
      </a:lvl1pPr>
      <a:lvl2pPr marL="1260020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4410" kern="1200">
          <a:solidFill>
            <a:schemeClr val="tx1"/>
          </a:solidFill>
          <a:latin typeface="+mn-lt"/>
          <a:ea typeface="+mn-ea"/>
          <a:cs typeface="+mn-cs"/>
        </a:defRPr>
      </a:lvl2pPr>
      <a:lvl3pPr marL="2100034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675" kern="1200">
          <a:solidFill>
            <a:schemeClr val="tx1"/>
          </a:solidFill>
          <a:latin typeface="+mn-lt"/>
          <a:ea typeface="+mn-ea"/>
          <a:cs typeface="+mn-cs"/>
        </a:defRPr>
      </a:lvl3pPr>
      <a:lvl4pPr marL="2940047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4pPr>
      <a:lvl5pPr marL="3780061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5pPr>
      <a:lvl6pPr marL="4620075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6pPr>
      <a:lvl7pPr marL="5460088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7pPr>
      <a:lvl8pPr marL="6300102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8pPr>
      <a:lvl9pPr marL="7140115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40014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680027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520041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4pPr>
      <a:lvl5pPr marL="3360054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5pPr>
      <a:lvl6pPr marL="4200068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6pPr>
      <a:lvl7pPr marL="5040081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7pPr>
      <a:lvl8pPr marL="5880095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8pPr>
      <a:lvl9pPr marL="6720108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826A67A4-14FB-4EEC-AFCD-00D6A5F71B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9540261"/>
              </p:ext>
            </p:extLst>
          </p:nvPr>
        </p:nvGraphicFramePr>
        <p:xfrm>
          <a:off x="1212436" y="4096983"/>
          <a:ext cx="5029763" cy="5994286"/>
        </p:xfrm>
        <a:graphic>
          <a:graphicData uri="http://schemas.openxmlformats.org/drawingml/2006/table">
            <a:tbl>
              <a:tblPr/>
              <a:tblGrid>
                <a:gridCol w="2643908">
                  <a:extLst>
                    <a:ext uri="{9D8B030D-6E8A-4147-A177-3AD203B41FA5}">
                      <a16:colId xmlns:a16="http://schemas.microsoft.com/office/drawing/2014/main" val="3912432834"/>
                    </a:ext>
                  </a:extLst>
                </a:gridCol>
                <a:gridCol w="1089855">
                  <a:extLst>
                    <a:ext uri="{9D8B030D-6E8A-4147-A177-3AD203B41FA5}">
                      <a16:colId xmlns:a16="http://schemas.microsoft.com/office/drawing/2014/main" val="2978537711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944572854"/>
                    </a:ext>
                  </a:extLst>
                </a:gridCol>
              </a:tblGrid>
              <a:tr h="35965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inic data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BM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2257935"/>
                  </a:ext>
                </a:extLst>
              </a:tr>
              <a:tr h="3596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asma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BMC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1646359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x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1E-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3E-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4640540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g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3E-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9E-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3299336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yslipidemia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0.08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0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4738650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ednisolon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94E-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0E-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6278458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ethylprednisolon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0E+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0E+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548443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lchicin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1E-0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5E-0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3235649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zathioprin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00E-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24E-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7675296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alazopyrin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01E-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82E-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4042853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ntoxyphylline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17E-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5E-0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652160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ilostazol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14E-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00E-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0884149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inocyclin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8E-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2E-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324592"/>
                  </a:ext>
                </a:extLst>
              </a:tr>
              <a:tr h="4395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tatin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1.00E+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ll samples are n</a:t>
                      </a:r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 treatment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4319536"/>
                  </a:ext>
                </a:extLst>
              </a:tr>
            </a:tbl>
          </a:graphicData>
        </a:graphic>
      </p:graphicFrame>
      <p:graphicFrame>
        <p:nvGraphicFramePr>
          <p:cNvPr id="27" name="표 27">
            <a:extLst>
              <a:ext uri="{FF2B5EF4-FFF2-40B4-BE49-F238E27FC236}">
                <a16:creationId xmlns:a16="http://schemas.microsoft.com/office/drawing/2014/main" id="{63744352-3DFF-4BF3-B15F-0977AFC740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8896109"/>
              </p:ext>
            </p:extLst>
          </p:nvPr>
        </p:nvGraphicFramePr>
        <p:xfrm>
          <a:off x="6658355" y="4096985"/>
          <a:ext cx="10584000" cy="51151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8000">
                  <a:extLst>
                    <a:ext uri="{9D8B030D-6E8A-4147-A177-3AD203B41FA5}">
                      <a16:colId xmlns:a16="http://schemas.microsoft.com/office/drawing/2014/main" val="676423715"/>
                    </a:ext>
                  </a:extLst>
                </a:gridCol>
                <a:gridCol w="2304000">
                  <a:extLst>
                    <a:ext uri="{9D8B030D-6E8A-4147-A177-3AD203B41FA5}">
                      <a16:colId xmlns:a16="http://schemas.microsoft.com/office/drawing/2014/main" val="643306852"/>
                    </a:ext>
                  </a:extLst>
                </a:gridCol>
                <a:gridCol w="2304000">
                  <a:extLst>
                    <a:ext uri="{9D8B030D-6E8A-4147-A177-3AD203B41FA5}">
                      <a16:colId xmlns:a16="http://schemas.microsoft.com/office/drawing/2014/main" val="2280856051"/>
                    </a:ext>
                  </a:extLst>
                </a:gridCol>
                <a:gridCol w="2304000">
                  <a:extLst>
                    <a:ext uri="{9D8B030D-6E8A-4147-A177-3AD203B41FA5}">
                      <a16:colId xmlns:a16="http://schemas.microsoft.com/office/drawing/2014/main" val="2387655403"/>
                    </a:ext>
                  </a:extLst>
                </a:gridCol>
                <a:gridCol w="2304000">
                  <a:extLst>
                    <a:ext uri="{9D8B030D-6E8A-4147-A177-3AD203B41FA5}">
                      <a16:colId xmlns:a16="http://schemas.microsoft.com/office/drawing/2014/main" val="373224706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erial / Confounder</a:t>
                      </a:r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68002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chicine</a:t>
                      </a:r>
                      <a:endParaRPr lang="ko-KR" alt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68002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azopyrine</a:t>
                      </a:r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68002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toxyphylline</a:t>
                      </a:r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3627217"/>
                  </a:ext>
                </a:extLst>
              </a:tr>
              <a:tr h="22680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</a:t>
                      </a:r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4908277"/>
                  </a:ext>
                </a:extLst>
              </a:tr>
              <a:tr h="22680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MC</a:t>
                      </a:r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5018222"/>
                  </a:ext>
                </a:extLst>
              </a:tr>
            </a:tbl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E331F36B-C0EC-4148-B51B-0527DDB67AE1}"/>
              </a:ext>
            </a:extLst>
          </p:cNvPr>
          <p:cNvSpPr txBox="1"/>
          <p:nvPr/>
        </p:nvSpPr>
        <p:spPr>
          <a:xfrm>
            <a:off x="1212436" y="3417712"/>
            <a:ext cx="8138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7985699-4A2A-4568-91FB-961A7A2C0979}"/>
              </a:ext>
            </a:extLst>
          </p:cNvPr>
          <p:cNvSpPr txBox="1"/>
          <p:nvPr/>
        </p:nvSpPr>
        <p:spPr>
          <a:xfrm>
            <a:off x="6658355" y="3417712"/>
            <a:ext cx="8138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77C6616-40AB-47D5-A3A3-B8A9EF5538EC}"/>
              </a:ext>
            </a:extLst>
          </p:cNvPr>
          <p:cNvSpPr txBox="1"/>
          <p:nvPr/>
        </p:nvSpPr>
        <p:spPr>
          <a:xfrm>
            <a:off x="699247" y="381734"/>
            <a:ext cx="1665858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Supplement figure 1) Evaluation for confounding effects of sex, age, dyslipidemia, and drugs in plasma and PBMC</a:t>
            </a: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b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 Sex, colchicine, </a:t>
            </a:r>
            <a:r>
              <a:rPr lang="en-US" altLang="ko-KR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alazopyrine</a:t>
            </a:r>
            <a:r>
              <a:rPr lang="en-US" altLang="ko-KR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 and </a:t>
            </a:r>
            <a:r>
              <a:rPr lang="en-US" altLang="ko-KR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entoxyphylline</a:t>
            </a:r>
            <a:r>
              <a:rPr lang="en-US" altLang="ko-KR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are significantly different according to groups (Fisher’s exact test, p&lt;0.05) (B) Score scatter plot of principal component analysis (PCA). The results suggested that there was no cluster according to potential confounders.</a:t>
            </a: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01E9A004-FBED-413E-8CBD-2AF2CACDB4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93391" y="4747684"/>
            <a:ext cx="2160000" cy="216000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BA390397-D3F3-4B7C-BB62-D19EF10D0E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96080" y="4770553"/>
            <a:ext cx="2160000" cy="2160000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4975F188-24A4-40AD-910E-98CDD8F74018}"/>
              </a:ext>
            </a:extLst>
          </p:cNvPr>
          <p:cNvSpPr txBox="1"/>
          <p:nvPr/>
        </p:nvSpPr>
        <p:spPr>
          <a:xfrm>
            <a:off x="11768262" y="6310367"/>
            <a:ext cx="7809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 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E86A945-F193-4333-BF1C-08F60A8AAEA0}"/>
              </a:ext>
            </a:extLst>
          </p:cNvPr>
          <p:cNvSpPr txBox="1"/>
          <p:nvPr/>
        </p:nvSpPr>
        <p:spPr>
          <a:xfrm>
            <a:off x="11768262" y="6477835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9" name="타원 38">
            <a:extLst>
              <a:ext uri="{FF2B5EF4-FFF2-40B4-BE49-F238E27FC236}">
                <a16:creationId xmlns:a16="http://schemas.microsoft.com/office/drawing/2014/main" id="{4CBAD5C5-FE6C-4284-A341-652D95A4ED43}"/>
              </a:ext>
            </a:extLst>
          </p:cNvPr>
          <p:cNvSpPr/>
          <p:nvPr/>
        </p:nvSpPr>
        <p:spPr>
          <a:xfrm>
            <a:off x="11723863" y="6364089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0" name="타원 39">
            <a:extLst>
              <a:ext uri="{FF2B5EF4-FFF2-40B4-BE49-F238E27FC236}">
                <a16:creationId xmlns:a16="http://schemas.microsoft.com/office/drawing/2014/main" id="{1623482E-B5E0-4218-9976-7B524984A040}"/>
              </a:ext>
            </a:extLst>
          </p:cNvPr>
          <p:cNvSpPr/>
          <p:nvPr/>
        </p:nvSpPr>
        <p:spPr>
          <a:xfrm>
            <a:off x="11723863" y="6531557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EEDC010-213B-481C-940A-5776B37A9839}"/>
              </a:ext>
            </a:extLst>
          </p:cNvPr>
          <p:cNvSpPr txBox="1"/>
          <p:nvPr/>
        </p:nvSpPr>
        <p:spPr>
          <a:xfrm>
            <a:off x="9615097" y="6310367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emale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DE22081-3B4B-4ABA-BB26-B0582C2390C7}"/>
              </a:ext>
            </a:extLst>
          </p:cNvPr>
          <p:cNvSpPr txBox="1"/>
          <p:nvPr/>
        </p:nvSpPr>
        <p:spPr>
          <a:xfrm>
            <a:off x="9615097" y="6477835"/>
            <a:ext cx="40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ale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5" name="타원 44">
            <a:extLst>
              <a:ext uri="{FF2B5EF4-FFF2-40B4-BE49-F238E27FC236}">
                <a16:creationId xmlns:a16="http://schemas.microsoft.com/office/drawing/2014/main" id="{684399AC-E029-44B6-8FE9-F3C2D512D5C7}"/>
              </a:ext>
            </a:extLst>
          </p:cNvPr>
          <p:cNvSpPr/>
          <p:nvPr/>
        </p:nvSpPr>
        <p:spPr>
          <a:xfrm>
            <a:off x="9570698" y="6364089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6" name="타원 45">
            <a:extLst>
              <a:ext uri="{FF2B5EF4-FFF2-40B4-BE49-F238E27FC236}">
                <a16:creationId xmlns:a16="http://schemas.microsoft.com/office/drawing/2014/main" id="{ADC737E1-AA9E-48E9-9DEE-64D75176E2AA}"/>
              </a:ext>
            </a:extLst>
          </p:cNvPr>
          <p:cNvSpPr/>
          <p:nvPr/>
        </p:nvSpPr>
        <p:spPr>
          <a:xfrm>
            <a:off x="9570698" y="6531557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1D818BDF-DAE3-4E3D-85EA-6EECE6F742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23977" y="4747684"/>
            <a:ext cx="2160000" cy="21600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EEFB83DB-1A16-4E0A-BBE4-7512BBAA2F1F}"/>
              </a:ext>
            </a:extLst>
          </p:cNvPr>
          <p:cNvSpPr txBox="1"/>
          <p:nvPr/>
        </p:nvSpPr>
        <p:spPr>
          <a:xfrm>
            <a:off x="14088719" y="6310367"/>
            <a:ext cx="7809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 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8723EA9-2E99-4EF1-A4BE-AC882962051B}"/>
              </a:ext>
            </a:extLst>
          </p:cNvPr>
          <p:cNvSpPr txBox="1"/>
          <p:nvPr/>
        </p:nvSpPr>
        <p:spPr>
          <a:xfrm>
            <a:off x="14088719" y="6477835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5" name="타원 34">
            <a:extLst>
              <a:ext uri="{FF2B5EF4-FFF2-40B4-BE49-F238E27FC236}">
                <a16:creationId xmlns:a16="http://schemas.microsoft.com/office/drawing/2014/main" id="{8295F884-4068-431D-9095-45C6B71EC1FC}"/>
              </a:ext>
            </a:extLst>
          </p:cNvPr>
          <p:cNvSpPr/>
          <p:nvPr/>
        </p:nvSpPr>
        <p:spPr>
          <a:xfrm>
            <a:off x="14044320" y="6364089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6" name="타원 35">
            <a:extLst>
              <a:ext uri="{FF2B5EF4-FFF2-40B4-BE49-F238E27FC236}">
                <a16:creationId xmlns:a16="http://schemas.microsoft.com/office/drawing/2014/main" id="{13A25FDB-9F29-42A6-87C2-746FA546C73E}"/>
              </a:ext>
            </a:extLst>
          </p:cNvPr>
          <p:cNvSpPr/>
          <p:nvPr/>
        </p:nvSpPr>
        <p:spPr>
          <a:xfrm>
            <a:off x="14044320" y="6531557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48" name="그림 47">
            <a:extLst>
              <a:ext uri="{FF2B5EF4-FFF2-40B4-BE49-F238E27FC236}">
                <a16:creationId xmlns:a16="http://schemas.microsoft.com/office/drawing/2014/main" id="{6A69ADBF-72C8-40C3-91FC-2BD185174A4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012233" y="4747684"/>
            <a:ext cx="2160000" cy="2160000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315F2E04-0D03-4AD3-B9D6-8226AF7FB707}"/>
              </a:ext>
            </a:extLst>
          </p:cNvPr>
          <p:cNvSpPr txBox="1"/>
          <p:nvPr/>
        </p:nvSpPr>
        <p:spPr>
          <a:xfrm>
            <a:off x="16380966" y="6310367"/>
            <a:ext cx="7809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 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68DEB1D-AB06-49F7-9DE2-241AF95ECEBB}"/>
              </a:ext>
            </a:extLst>
          </p:cNvPr>
          <p:cNvSpPr txBox="1"/>
          <p:nvPr/>
        </p:nvSpPr>
        <p:spPr>
          <a:xfrm>
            <a:off x="16380966" y="6477835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1" name="타원 50">
            <a:extLst>
              <a:ext uri="{FF2B5EF4-FFF2-40B4-BE49-F238E27FC236}">
                <a16:creationId xmlns:a16="http://schemas.microsoft.com/office/drawing/2014/main" id="{24012FC7-2F02-4A55-9D6B-FDCFD3ED5C4F}"/>
              </a:ext>
            </a:extLst>
          </p:cNvPr>
          <p:cNvSpPr/>
          <p:nvPr/>
        </p:nvSpPr>
        <p:spPr>
          <a:xfrm>
            <a:off x="16336567" y="6364089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2" name="타원 51">
            <a:extLst>
              <a:ext uri="{FF2B5EF4-FFF2-40B4-BE49-F238E27FC236}">
                <a16:creationId xmlns:a16="http://schemas.microsoft.com/office/drawing/2014/main" id="{8D6B473E-253F-4281-A843-8E07C0D3AA77}"/>
              </a:ext>
            </a:extLst>
          </p:cNvPr>
          <p:cNvSpPr/>
          <p:nvPr/>
        </p:nvSpPr>
        <p:spPr>
          <a:xfrm>
            <a:off x="16336567" y="6531557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54" name="그림 53">
            <a:extLst>
              <a:ext uri="{FF2B5EF4-FFF2-40B4-BE49-F238E27FC236}">
                <a16:creationId xmlns:a16="http://schemas.microsoft.com/office/drawing/2014/main" id="{E93CF5EB-1F03-4691-95A9-2565EAC271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012233" y="7015681"/>
            <a:ext cx="2160000" cy="2160000"/>
          </a:xfrm>
          <a:prstGeom prst="rect">
            <a:avLst/>
          </a:prstGeom>
        </p:spPr>
      </p:pic>
      <p:pic>
        <p:nvPicPr>
          <p:cNvPr id="56" name="그림 55">
            <a:extLst>
              <a:ext uri="{FF2B5EF4-FFF2-40B4-BE49-F238E27FC236}">
                <a16:creationId xmlns:a16="http://schemas.microsoft.com/office/drawing/2014/main" id="{04B991C1-3A90-4694-84C6-93206294EDC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726511" y="7015681"/>
            <a:ext cx="2160000" cy="2160000"/>
          </a:xfrm>
          <a:prstGeom prst="rect">
            <a:avLst/>
          </a:prstGeom>
        </p:spPr>
      </p:pic>
      <p:pic>
        <p:nvPicPr>
          <p:cNvPr id="58" name="그림 57">
            <a:extLst>
              <a:ext uri="{FF2B5EF4-FFF2-40B4-BE49-F238E27FC236}">
                <a16:creationId xmlns:a16="http://schemas.microsoft.com/office/drawing/2014/main" id="{3ACBB666-E1FA-4114-A056-669693DAE6C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96080" y="7015681"/>
            <a:ext cx="2160000" cy="2160000"/>
          </a:xfrm>
          <a:prstGeom prst="rect">
            <a:avLst/>
          </a:prstGeom>
        </p:spPr>
      </p:pic>
      <p:pic>
        <p:nvPicPr>
          <p:cNvPr id="60" name="그림 59">
            <a:extLst>
              <a:ext uri="{FF2B5EF4-FFF2-40B4-BE49-F238E27FC236}">
                <a16:creationId xmlns:a16="http://schemas.microsoft.com/office/drawing/2014/main" id="{2473DE9D-E909-4BFB-A270-C6D2E63A13D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78845" y="7015681"/>
            <a:ext cx="2160000" cy="2160000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E9C0EE2A-B0E7-4507-9A20-849341203209}"/>
              </a:ext>
            </a:extLst>
          </p:cNvPr>
          <p:cNvSpPr txBox="1"/>
          <p:nvPr/>
        </p:nvSpPr>
        <p:spPr>
          <a:xfrm>
            <a:off x="11768262" y="8569818"/>
            <a:ext cx="7809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 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3048131-F643-40AA-A0DA-4FC941098351}"/>
              </a:ext>
            </a:extLst>
          </p:cNvPr>
          <p:cNvSpPr txBox="1"/>
          <p:nvPr/>
        </p:nvSpPr>
        <p:spPr>
          <a:xfrm>
            <a:off x="11768262" y="8737286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3" name="타원 62">
            <a:extLst>
              <a:ext uri="{FF2B5EF4-FFF2-40B4-BE49-F238E27FC236}">
                <a16:creationId xmlns:a16="http://schemas.microsoft.com/office/drawing/2014/main" id="{DBC65635-5102-4F65-9BC1-C16CC5501E34}"/>
              </a:ext>
            </a:extLst>
          </p:cNvPr>
          <p:cNvSpPr/>
          <p:nvPr/>
        </p:nvSpPr>
        <p:spPr>
          <a:xfrm>
            <a:off x="11723863" y="8623540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4" name="타원 63">
            <a:extLst>
              <a:ext uri="{FF2B5EF4-FFF2-40B4-BE49-F238E27FC236}">
                <a16:creationId xmlns:a16="http://schemas.microsoft.com/office/drawing/2014/main" id="{CDEBD06D-6566-4D8A-96A2-BD9D20E38278}"/>
              </a:ext>
            </a:extLst>
          </p:cNvPr>
          <p:cNvSpPr/>
          <p:nvPr/>
        </p:nvSpPr>
        <p:spPr>
          <a:xfrm>
            <a:off x="11723863" y="8791008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FB40C24-EE1B-45DD-9B5F-C8353CAF7F01}"/>
              </a:ext>
            </a:extLst>
          </p:cNvPr>
          <p:cNvSpPr txBox="1"/>
          <p:nvPr/>
        </p:nvSpPr>
        <p:spPr>
          <a:xfrm>
            <a:off x="9615097" y="856981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emale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01512B4-E47C-4DF4-8833-A8FB54CACF15}"/>
              </a:ext>
            </a:extLst>
          </p:cNvPr>
          <p:cNvSpPr txBox="1"/>
          <p:nvPr/>
        </p:nvSpPr>
        <p:spPr>
          <a:xfrm>
            <a:off x="9615097" y="8737286"/>
            <a:ext cx="40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ale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7" name="타원 66">
            <a:extLst>
              <a:ext uri="{FF2B5EF4-FFF2-40B4-BE49-F238E27FC236}">
                <a16:creationId xmlns:a16="http://schemas.microsoft.com/office/drawing/2014/main" id="{E2C2ADE5-CD31-4486-ADD5-AA31965B19F5}"/>
              </a:ext>
            </a:extLst>
          </p:cNvPr>
          <p:cNvSpPr/>
          <p:nvPr/>
        </p:nvSpPr>
        <p:spPr>
          <a:xfrm>
            <a:off x="9570698" y="8623540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8" name="타원 67">
            <a:extLst>
              <a:ext uri="{FF2B5EF4-FFF2-40B4-BE49-F238E27FC236}">
                <a16:creationId xmlns:a16="http://schemas.microsoft.com/office/drawing/2014/main" id="{A6FDAAFE-3DBB-4F5A-94C4-B5B28D78C994}"/>
              </a:ext>
            </a:extLst>
          </p:cNvPr>
          <p:cNvSpPr/>
          <p:nvPr/>
        </p:nvSpPr>
        <p:spPr>
          <a:xfrm>
            <a:off x="9570698" y="8791008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AABB501-911F-4F54-8E59-867062FEA507}"/>
              </a:ext>
            </a:extLst>
          </p:cNvPr>
          <p:cNvSpPr txBox="1"/>
          <p:nvPr/>
        </p:nvSpPr>
        <p:spPr>
          <a:xfrm>
            <a:off x="14088719" y="8569818"/>
            <a:ext cx="7809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 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43FB118-EAA4-4351-80CF-2B543A4C6F0C}"/>
              </a:ext>
            </a:extLst>
          </p:cNvPr>
          <p:cNvSpPr txBox="1"/>
          <p:nvPr/>
        </p:nvSpPr>
        <p:spPr>
          <a:xfrm>
            <a:off x="14088719" y="8737286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1" name="타원 70">
            <a:extLst>
              <a:ext uri="{FF2B5EF4-FFF2-40B4-BE49-F238E27FC236}">
                <a16:creationId xmlns:a16="http://schemas.microsoft.com/office/drawing/2014/main" id="{C642FB52-68E5-4D4C-AF28-385D0B67F8C5}"/>
              </a:ext>
            </a:extLst>
          </p:cNvPr>
          <p:cNvSpPr/>
          <p:nvPr/>
        </p:nvSpPr>
        <p:spPr>
          <a:xfrm>
            <a:off x="14044320" y="8623540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2" name="타원 71">
            <a:extLst>
              <a:ext uri="{FF2B5EF4-FFF2-40B4-BE49-F238E27FC236}">
                <a16:creationId xmlns:a16="http://schemas.microsoft.com/office/drawing/2014/main" id="{6201636C-CEA5-4A5B-A612-04817AAE3005}"/>
              </a:ext>
            </a:extLst>
          </p:cNvPr>
          <p:cNvSpPr/>
          <p:nvPr/>
        </p:nvSpPr>
        <p:spPr>
          <a:xfrm>
            <a:off x="14044320" y="8791008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1347255-F16E-4BCB-842F-A964C4B68B94}"/>
              </a:ext>
            </a:extLst>
          </p:cNvPr>
          <p:cNvSpPr txBox="1"/>
          <p:nvPr/>
        </p:nvSpPr>
        <p:spPr>
          <a:xfrm>
            <a:off x="16380966" y="8569818"/>
            <a:ext cx="7809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 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FFC37A2-1DCE-4150-9EAD-F7D175B410DF}"/>
              </a:ext>
            </a:extLst>
          </p:cNvPr>
          <p:cNvSpPr txBox="1"/>
          <p:nvPr/>
        </p:nvSpPr>
        <p:spPr>
          <a:xfrm>
            <a:off x="16380966" y="8737286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eatment</a:t>
            </a:r>
            <a:endParaRPr kumimoji="0" lang="ko-KR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5" name="타원 74">
            <a:extLst>
              <a:ext uri="{FF2B5EF4-FFF2-40B4-BE49-F238E27FC236}">
                <a16:creationId xmlns:a16="http://schemas.microsoft.com/office/drawing/2014/main" id="{1E26CF2A-56AC-4F24-869D-24BE91479977}"/>
              </a:ext>
            </a:extLst>
          </p:cNvPr>
          <p:cNvSpPr/>
          <p:nvPr/>
        </p:nvSpPr>
        <p:spPr>
          <a:xfrm>
            <a:off x="16336567" y="8623540"/>
            <a:ext cx="108000" cy="108000"/>
          </a:xfrm>
          <a:prstGeom prst="ellipse">
            <a:avLst/>
          </a:prstGeom>
          <a:solidFill>
            <a:srgbClr val="0001FC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6" name="타원 75">
            <a:extLst>
              <a:ext uri="{FF2B5EF4-FFF2-40B4-BE49-F238E27FC236}">
                <a16:creationId xmlns:a16="http://schemas.microsoft.com/office/drawing/2014/main" id="{516C0910-532F-4ACF-9A36-8AB6CCC663E5}"/>
              </a:ext>
            </a:extLst>
          </p:cNvPr>
          <p:cNvSpPr/>
          <p:nvPr/>
        </p:nvSpPr>
        <p:spPr>
          <a:xfrm>
            <a:off x="16336567" y="8791008"/>
            <a:ext cx="108000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57463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8A0A4763-1008-48F7-ACF7-585CE1F2273F}"/>
              </a:ext>
            </a:extLst>
          </p:cNvPr>
          <p:cNvGrpSpPr/>
          <p:nvPr/>
        </p:nvGrpSpPr>
        <p:grpSpPr>
          <a:xfrm>
            <a:off x="3547191" y="3362022"/>
            <a:ext cx="10906281" cy="5343828"/>
            <a:chOff x="12939428" y="4843322"/>
            <a:chExt cx="6135445" cy="5343828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0F3D742-C28D-433E-8AF3-2F21940A046C}"/>
                </a:ext>
              </a:extLst>
            </p:cNvPr>
            <p:cNvSpPr txBox="1"/>
            <p:nvPr/>
          </p:nvSpPr>
          <p:spPr>
            <a:xfrm>
              <a:off x="12939428" y="5622570"/>
              <a:ext cx="192759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b="1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BD specific features</a:t>
              </a:r>
            </a:p>
          </p:txBody>
        </p:sp>
        <p:sp>
          <p:nvSpPr>
            <p:cNvPr id="6" name="타원 5">
              <a:extLst>
                <a:ext uri="{FF2B5EF4-FFF2-40B4-BE49-F238E27FC236}">
                  <a16:creationId xmlns:a16="http://schemas.microsoft.com/office/drawing/2014/main" id="{A9390E92-970F-4FED-A1F6-9255EFFD8A9D}"/>
                </a:ext>
              </a:extLst>
            </p:cNvPr>
            <p:cNvSpPr/>
            <p:nvPr/>
          </p:nvSpPr>
          <p:spPr>
            <a:xfrm>
              <a:off x="14947237" y="5359503"/>
              <a:ext cx="2590666" cy="4827647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/>
            </a:p>
          </p:txBody>
        </p:sp>
        <p:sp>
          <p:nvSpPr>
            <p:cNvPr id="7" name="타원 6">
              <a:extLst>
                <a:ext uri="{FF2B5EF4-FFF2-40B4-BE49-F238E27FC236}">
                  <a16:creationId xmlns:a16="http://schemas.microsoft.com/office/drawing/2014/main" id="{CE3B6C62-DC6B-4B1E-B95F-C4E8E26B22AB}"/>
                </a:ext>
              </a:extLst>
            </p:cNvPr>
            <p:cNvSpPr/>
            <p:nvPr/>
          </p:nvSpPr>
          <p:spPr>
            <a:xfrm>
              <a:off x="16484207" y="5359503"/>
              <a:ext cx="2590666" cy="4827647"/>
            </a:xfrm>
            <a:prstGeom prst="ellipse">
              <a:avLst/>
            </a:prstGeom>
            <a:solidFill>
              <a:schemeClr val="accent2">
                <a:alpha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70F8437-6669-4E8B-9327-D108F00D0F15}"/>
                </a:ext>
              </a:extLst>
            </p:cNvPr>
            <p:cNvSpPr txBox="1"/>
            <p:nvPr/>
          </p:nvSpPr>
          <p:spPr>
            <a:xfrm>
              <a:off x="15812804" y="4843322"/>
              <a:ext cx="6738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HC vs BD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931F999-3C49-4A67-82DE-ADCC55D5FA6E}"/>
                </a:ext>
              </a:extLst>
            </p:cNvPr>
            <p:cNvSpPr txBox="1"/>
            <p:nvPr/>
          </p:nvSpPr>
          <p:spPr>
            <a:xfrm>
              <a:off x="17537903" y="4843322"/>
              <a:ext cx="681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HC vs DC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E02142-00C3-4E7D-A6EA-AA376F420C6F}"/>
                </a:ext>
              </a:extLst>
            </p:cNvPr>
            <p:cNvSpPr txBox="1"/>
            <p:nvPr/>
          </p:nvSpPr>
          <p:spPr>
            <a:xfrm>
              <a:off x="16793224" y="7515235"/>
              <a:ext cx="2481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E0A26FA-02F2-43D5-8B56-0529C81B5C15}"/>
                </a:ext>
              </a:extLst>
            </p:cNvPr>
            <p:cNvSpPr txBox="1"/>
            <p:nvPr/>
          </p:nvSpPr>
          <p:spPr>
            <a:xfrm>
              <a:off x="15635512" y="7515235"/>
              <a:ext cx="2481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6924259-41CD-4903-8F06-302E1C5E431B}"/>
                </a:ext>
              </a:extLst>
            </p:cNvPr>
            <p:cNvSpPr txBox="1"/>
            <p:nvPr/>
          </p:nvSpPr>
          <p:spPr>
            <a:xfrm>
              <a:off x="18032011" y="7515235"/>
              <a:ext cx="2481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직선 화살표 연결선 12">
              <a:extLst>
                <a:ext uri="{FF2B5EF4-FFF2-40B4-BE49-F238E27FC236}">
                  <a16:creationId xmlns:a16="http://schemas.microsoft.com/office/drawing/2014/main" id="{2E84D4E4-31D9-4AB4-AE7C-BAF0EF929257}"/>
                </a:ext>
              </a:extLst>
            </p:cNvPr>
            <p:cNvCxnSpPr/>
            <p:nvPr/>
          </p:nvCxnSpPr>
          <p:spPr>
            <a:xfrm flipH="1">
              <a:off x="14508153" y="7675839"/>
              <a:ext cx="102522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4AA5875F-8FDD-452B-B973-BDAA423E39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7103810"/>
              </p:ext>
            </p:extLst>
          </p:nvPr>
        </p:nvGraphicFramePr>
        <p:xfrm>
          <a:off x="3628628" y="4783267"/>
          <a:ext cx="3263596" cy="3240000"/>
        </p:xfrm>
        <a:graphic>
          <a:graphicData uri="http://schemas.openxmlformats.org/drawingml/2006/table">
            <a:tbl>
              <a:tblPr/>
              <a:tblGrid>
                <a:gridCol w="3263596">
                  <a:extLst>
                    <a:ext uri="{9D8B030D-6E8A-4147-A177-3AD203B41FA5}">
                      <a16:colId xmlns:a16="http://schemas.microsoft.com/office/drawing/2014/main" val="371539411"/>
                    </a:ext>
                  </a:extLst>
                </a:gridCol>
              </a:tblGrid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8:2 (2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54904019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lutamate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573478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PE O-18: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80454529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6: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4378312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lycolic acid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358695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yrophosphate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07964738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henylalanine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86572719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xoproline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54715167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28:7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1166070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38:4;2O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63693668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5B99CFEC-6CB3-42A4-B19A-03ED0981ECD2}"/>
              </a:ext>
            </a:extLst>
          </p:cNvPr>
          <p:cNvSpPr txBox="1"/>
          <p:nvPr/>
        </p:nvSpPr>
        <p:spPr>
          <a:xfrm>
            <a:off x="699247" y="381734"/>
            <a:ext cx="1665858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>
                <a:latin typeface="Arial" panose="020B0604020202020204" pitchFamily="34" charset="0"/>
                <a:cs typeface="Arial" panose="020B0604020202020204" pitchFamily="34" charset="0"/>
              </a:rPr>
              <a:t>(Supplement figure 2) The metabolite list of BD specific features in plasma</a:t>
            </a: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br>
              <a:rPr lang="en-US" altLang="ko-KR" sz="2400" b="1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ed and blue indicate the metabolites that are significantly up and down-regulated in BD, respectively (Mann-Whitney test, p&lt;0.05)</a:t>
            </a:r>
          </a:p>
        </p:txBody>
      </p:sp>
    </p:spTree>
    <p:extLst>
      <p:ext uri="{BB962C8B-B14F-4D97-AF65-F5344CB8AC3E}">
        <p14:creationId xmlns:p14="http://schemas.microsoft.com/office/powerpoint/2010/main" val="1365009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3534630A-6A10-44BF-A307-CE117BD6B519}"/>
              </a:ext>
            </a:extLst>
          </p:cNvPr>
          <p:cNvGrpSpPr/>
          <p:nvPr/>
        </p:nvGrpSpPr>
        <p:grpSpPr>
          <a:xfrm>
            <a:off x="4003117" y="3854662"/>
            <a:ext cx="9927908" cy="4151668"/>
            <a:chOff x="12629545" y="2599078"/>
            <a:chExt cx="6445330" cy="2867665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A56D370-0455-4138-8489-75703EA8B87C}"/>
                </a:ext>
              </a:extLst>
            </p:cNvPr>
            <p:cNvSpPr txBox="1"/>
            <p:nvPr/>
          </p:nvSpPr>
          <p:spPr>
            <a:xfrm>
              <a:off x="12629545" y="2599078"/>
              <a:ext cx="1927599" cy="25510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b="1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BD specific features</a:t>
              </a:r>
            </a:p>
          </p:txBody>
        </p:sp>
        <p:sp>
          <p:nvSpPr>
            <p:cNvPr id="4" name="타원 3">
              <a:extLst>
                <a:ext uri="{FF2B5EF4-FFF2-40B4-BE49-F238E27FC236}">
                  <a16:creationId xmlns:a16="http://schemas.microsoft.com/office/drawing/2014/main" id="{62AB6EE4-E4BA-409E-B953-FCE8AE4FD670}"/>
                </a:ext>
              </a:extLst>
            </p:cNvPr>
            <p:cNvSpPr/>
            <p:nvPr/>
          </p:nvSpPr>
          <p:spPr>
            <a:xfrm>
              <a:off x="14947239" y="2876077"/>
              <a:ext cx="2590666" cy="2590666"/>
            </a:xfrm>
            <a:prstGeom prst="ellipse">
              <a:avLst/>
            </a:prstGeom>
            <a:solidFill>
              <a:schemeClr val="accent1">
                <a:alpha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/>
            </a:p>
          </p:txBody>
        </p:sp>
        <p:sp>
          <p:nvSpPr>
            <p:cNvPr id="5" name="타원 4">
              <a:extLst>
                <a:ext uri="{FF2B5EF4-FFF2-40B4-BE49-F238E27FC236}">
                  <a16:creationId xmlns:a16="http://schemas.microsoft.com/office/drawing/2014/main" id="{E9CB9E87-CCBD-41C1-8EAA-981C8DE4A600}"/>
                </a:ext>
              </a:extLst>
            </p:cNvPr>
            <p:cNvSpPr/>
            <p:nvPr/>
          </p:nvSpPr>
          <p:spPr>
            <a:xfrm>
              <a:off x="16484209" y="2876077"/>
              <a:ext cx="2590666" cy="2590666"/>
            </a:xfrm>
            <a:prstGeom prst="ellipse">
              <a:avLst/>
            </a:prstGeom>
            <a:solidFill>
              <a:schemeClr val="accent2">
                <a:alpha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80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8134B83-19FD-4CC7-82A3-7DFB5A33B0C3}"/>
                </a:ext>
              </a:extLst>
            </p:cNvPr>
            <p:cNvSpPr txBox="1"/>
            <p:nvPr/>
          </p:nvSpPr>
          <p:spPr>
            <a:xfrm>
              <a:off x="15812806" y="2599078"/>
              <a:ext cx="777604" cy="255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HC vs BD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7F6C4E9-F1B0-4759-88F2-4727C300295E}"/>
                </a:ext>
              </a:extLst>
            </p:cNvPr>
            <p:cNvSpPr txBox="1"/>
            <p:nvPr/>
          </p:nvSpPr>
          <p:spPr>
            <a:xfrm>
              <a:off x="17349776" y="2599078"/>
              <a:ext cx="777604" cy="255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DC vs BD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2627789-F1A3-468B-9643-6346A26FF6D5}"/>
                </a:ext>
              </a:extLst>
            </p:cNvPr>
            <p:cNvSpPr txBox="1"/>
            <p:nvPr/>
          </p:nvSpPr>
          <p:spPr>
            <a:xfrm>
              <a:off x="16793226" y="4032910"/>
              <a:ext cx="286398" cy="255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9DBA744-BA14-45FE-9DBB-78D56F893E7F}"/>
                </a:ext>
              </a:extLst>
            </p:cNvPr>
            <p:cNvSpPr txBox="1"/>
            <p:nvPr/>
          </p:nvSpPr>
          <p:spPr>
            <a:xfrm>
              <a:off x="15635514" y="4032910"/>
              <a:ext cx="286398" cy="255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825FE38-AD11-4754-8B9D-BA07B370D3C7}"/>
                </a:ext>
              </a:extLst>
            </p:cNvPr>
            <p:cNvSpPr txBox="1"/>
            <p:nvPr/>
          </p:nvSpPr>
          <p:spPr>
            <a:xfrm>
              <a:off x="18032015" y="4032910"/>
              <a:ext cx="286398" cy="255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latin typeface="Arial" panose="020B0604020202020204" pitchFamily="34" charset="0"/>
                  <a:cs typeface="Arial" panose="020B0604020202020204" pitchFamily="34" charset="0"/>
                </a:rPr>
                <a:t>62</a:t>
              </a:r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직선 화살표 연결선 10">
              <a:extLst>
                <a:ext uri="{FF2B5EF4-FFF2-40B4-BE49-F238E27FC236}">
                  <a16:creationId xmlns:a16="http://schemas.microsoft.com/office/drawing/2014/main" id="{67CD5888-793F-4418-823A-B2F37A914BCF}"/>
                </a:ext>
              </a:extLst>
            </p:cNvPr>
            <p:cNvCxnSpPr/>
            <p:nvPr/>
          </p:nvCxnSpPr>
          <p:spPr>
            <a:xfrm flipH="1">
              <a:off x="14557144" y="4171409"/>
              <a:ext cx="102522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3" name="표 12">
            <a:extLst>
              <a:ext uri="{FF2B5EF4-FFF2-40B4-BE49-F238E27FC236}">
                <a16:creationId xmlns:a16="http://schemas.microsoft.com/office/drawing/2014/main" id="{23FB490A-DC71-4CB1-9EA9-5BA11C4A78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1893872"/>
              </p:ext>
            </p:extLst>
          </p:nvPr>
        </p:nvGraphicFramePr>
        <p:xfrm>
          <a:off x="3307456" y="4312071"/>
          <a:ext cx="4360451" cy="4313820"/>
        </p:xfrm>
        <a:graphic>
          <a:graphicData uri="http://schemas.openxmlformats.org/drawingml/2006/table">
            <a:tbl>
              <a:tblPr/>
              <a:tblGrid>
                <a:gridCol w="4360451">
                  <a:extLst>
                    <a:ext uri="{9D8B030D-6E8A-4147-A177-3AD203B41FA5}">
                      <a16:colId xmlns:a16="http://schemas.microsoft.com/office/drawing/2014/main" val="3266766527"/>
                    </a:ext>
                  </a:extLst>
                </a:gridCol>
              </a:tblGrid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L 81:16</a:t>
                      </a:r>
                    </a:p>
                  </a:txBody>
                  <a:tcPr marL="0" marR="0" marT="0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52022806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35:6 </a:t>
                      </a:r>
                      <a:r>
                        <a:rPr lang="en-US" altLang="ko-KR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(2)</a:t>
                      </a:r>
                      <a:endParaRPr lang="en-US" sz="16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4504132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36:2;2O </a:t>
                      </a:r>
                      <a:r>
                        <a:rPr lang="en-US" altLang="ko-KR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(2)</a:t>
                      </a:r>
                      <a:endParaRPr lang="en-US" sz="16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72966034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O-32:1</a:t>
                      </a:r>
                    </a:p>
                  </a:txBody>
                  <a:tcPr marL="0" marR="0" marT="0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34856112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MPE 34: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16925327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-Imidazoleacrylic acid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7602957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36:2;O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95586550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36: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38318580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O-35:5 </a:t>
                      </a:r>
                      <a:r>
                        <a:rPr lang="en-US" altLang="ko-KR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ko-KR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)</a:t>
                      </a:r>
                      <a:endParaRPr lang="en-US" sz="16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4874552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AE 7: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7475485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L 80: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2459086"/>
                  </a:ext>
                </a:extLst>
              </a:tr>
              <a:tr h="35948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NAPE 38:5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35449922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8EBCF41B-EE80-41BD-A4B5-B00C6ED484F3}"/>
              </a:ext>
            </a:extLst>
          </p:cNvPr>
          <p:cNvSpPr txBox="1"/>
          <p:nvPr/>
        </p:nvSpPr>
        <p:spPr>
          <a:xfrm>
            <a:off x="699247" y="381734"/>
            <a:ext cx="1665858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Supplement figure 3) The metabolite list of BD specific features in PBMC</a:t>
            </a: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b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ed and blue indicate the metabolites that are significantly up and down-regulated in BD, respectively (Mann-Whitney test, p&lt;0.05)</a:t>
            </a:r>
          </a:p>
        </p:txBody>
      </p:sp>
    </p:spTree>
    <p:extLst>
      <p:ext uri="{BB962C8B-B14F-4D97-AF65-F5344CB8AC3E}">
        <p14:creationId xmlns:p14="http://schemas.microsoft.com/office/powerpoint/2010/main" val="11923309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A8F454-8878-477C-BA8E-4D1872D3D6CF}"/>
              </a:ext>
            </a:extLst>
          </p:cNvPr>
          <p:cNvSpPr txBox="1"/>
          <p:nvPr/>
        </p:nvSpPr>
        <p:spPr>
          <a:xfrm>
            <a:off x="699247" y="381734"/>
            <a:ext cx="1665858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Supplement figure 4) The metabolites showing associated with clinical phenotype</a:t>
            </a: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b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 Explained variance of clinical phenotype by PERMANOVA. (* : p-value &lt; 0.05) (B) The list of the metabolites correlated with clinical phenotype. The coefficient and p-value are calculated based on multiple linear regression</a:t>
            </a:r>
          </a:p>
        </p:txBody>
      </p:sp>
      <p:graphicFrame>
        <p:nvGraphicFramePr>
          <p:cNvPr id="4" name="차트 3">
            <a:extLst>
              <a:ext uri="{FF2B5EF4-FFF2-40B4-BE49-F238E27FC236}">
                <a16:creationId xmlns:a16="http://schemas.microsoft.com/office/drawing/2014/main" id="{97665F42-DFF7-1006-4802-B7AADA3018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3610340"/>
              </p:ext>
            </p:extLst>
          </p:nvPr>
        </p:nvGraphicFramePr>
        <p:xfrm>
          <a:off x="1634940" y="2653153"/>
          <a:ext cx="7120297" cy="3389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차트 4">
            <a:extLst>
              <a:ext uri="{FF2B5EF4-FFF2-40B4-BE49-F238E27FC236}">
                <a16:creationId xmlns:a16="http://schemas.microsoft.com/office/drawing/2014/main" id="{ED70B4DE-113B-7AE6-113F-7AECBB99E3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1046692"/>
              </p:ext>
            </p:extLst>
          </p:nvPr>
        </p:nvGraphicFramePr>
        <p:xfrm>
          <a:off x="9028540" y="2653153"/>
          <a:ext cx="7108526" cy="3389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7AF3BE41-B9AE-1888-CC0B-A8578541FB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6749706"/>
              </p:ext>
            </p:extLst>
          </p:nvPr>
        </p:nvGraphicFramePr>
        <p:xfrm>
          <a:off x="1970116" y="6757193"/>
          <a:ext cx="14060430" cy="4813479"/>
        </p:xfrm>
        <a:graphic>
          <a:graphicData uri="http://schemas.openxmlformats.org/drawingml/2006/table">
            <a:tbl>
              <a:tblPr/>
              <a:tblGrid>
                <a:gridCol w="2390931">
                  <a:extLst>
                    <a:ext uri="{9D8B030D-6E8A-4147-A177-3AD203B41FA5}">
                      <a16:colId xmlns:a16="http://schemas.microsoft.com/office/drawing/2014/main" val="4042974691"/>
                    </a:ext>
                  </a:extLst>
                </a:gridCol>
                <a:gridCol w="1414818">
                  <a:extLst>
                    <a:ext uri="{9D8B030D-6E8A-4147-A177-3AD203B41FA5}">
                      <a16:colId xmlns:a16="http://schemas.microsoft.com/office/drawing/2014/main" val="2232194536"/>
                    </a:ext>
                  </a:extLst>
                </a:gridCol>
                <a:gridCol w="690957">
                  <a:extLst>
                    <a:ext uri="{9D8B030D-6E8A-4147-A177-3AD203B41FA5}">
                      <a16:colId xmlns:a16="http://schemas.microsoft.com/office/drawing/2014/main" val="3439434912"/>
                    </a:ext>
                  </a:extLst>
                </a:gridCol>
                <a:gridCol w="2752861">
                  <a:extLst>
                    <a:ext uri="{9D8B030D-6E8A-4147-A177-3AD203B41FA5}">
                      <a16:colId xmlns:a16="http://schemas.microsoft.com/office/drawing/2014/main" val="4278251906"/>
                    </a:ext>
                  </a:extLst>
                </a:gridCol>
                <a:gridCol w="910308">
                  <a:extLst>
                    <a:ext uri="{9D8B030D-6E8A-4147-A177-3AD203B41FA5}">
                      <a16:colId xmlns:a16="http://schemas.microsoft.com/office/drawing/2014/main" val="484747097"/>
                    </a:ext>
                  </a:extLst>
                </a:gridCol>
                <a:gridCol w="690957">
                  <a:extLst>
                    <a:ext uri="{9D8B030D-6E8A-4147-A177-3AD203B41FA5}">
                      <a16:colId xmlns:a16="http://schemas.microsoft.com/office/drawing/2014/main" val="4253593400"/>
                    </a:ext>
                  </a:extLst>
                </a:gridCol>
                <a:gridCol w="2906407">
                  <a:extLst>
                    <a:ext uri="{9D8B030D-6E8A-4147-A177-3AD203B41FA5}">
                      <a16:colId xmlns:a16="http://schemas.microsoft.com/office/drawing/2014/main" val="2966649903"/>
                    </a:ext>
                  </a:extLst>
                </a:gridCol>
                <a:gridCol w="1261271">
                  <a:extLst>
                    <a:ext uri="{9D8B030D-6E8A-4147-A177-3AD203B41FA5}">
                      <a16:colId xmlns:a16="http://schemas.microsoft.com/office/drawing/2014/main" val="184931764"/>
                    </a:ext>
                  </a:extLst>
                </a:gridCol>
                <a:gridCol w="1041920">
                  <a:extLst>
                    <a:ext uri="{9D8B030D-6E8A-4147-A177-3AD203B41FA5}">
                      <a16:colId xmlns:a16="http://schemas.microsoft.com/office/drawing/2014/main" val="3666388848"/>
                    </a:ext>
                  </a:extLst>
                </a:gridCol>
              </a:tblGrid>
              <a:tr h="253341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lasma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BMC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6435906"/>
                  </a:ext>
                </a:extLst>
              </a:tr>
              <a:tr h="253341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enital ulcer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enital ulcer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NA antibody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7869309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mpounds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efficient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mpounds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efficient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mpounds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efficient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0673582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lycolic acid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7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38:4;O (PE 18:1_20:3;O) (2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1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L 74:1 (CL 16:0_16:0_24:0_18:1) (3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3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6035443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erine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38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9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O-36:3 (PE O-18:1_18:2) (4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653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MPE 34:1 (DMPE 16:0_18:1) (2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28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8679442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4:0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0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r 42:2;2O (Cer 18:1;2O/24:1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67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3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r 34:1;2O (Cer 18:1;2O/16:0) (1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0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8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719046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28:7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99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rethisterone acetate (1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68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3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I 38:4;O (PI 18:0_20:4;O) (2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9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9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5294380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38:5;2O (PE 20:5_18:0;2O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98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S 36:1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69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33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O-38:5 (PE O-18:1_20:4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61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1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0720506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PE O-18:1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8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O-40:7 (PE O-18:1_22:6) (2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71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28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38:4 (PC 18:0_20:4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41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3864416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M 33:1;2O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9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3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I 38:4;O (PI 18:0_20:4;O) (2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771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O-40:6 (PE O-18:1_22:5) (1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28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6737945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aurine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6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I 38:4 (PI 18:0_20:4) (5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2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9238702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9:5;2O (2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58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38:2 (PC 18:1_20:1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20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4820641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ructose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619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31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O-34:5 (1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8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21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9681257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agatose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65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2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O-38:5 (PE O-16:1_22:4) (3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8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0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5164231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thanolamine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69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15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6:4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73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3189162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36:1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69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4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0964693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 O-36:3 (PE O-18:1_18:2) (1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66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7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5395347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36:4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52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9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3515219"/>
                  </a:ext>
                </a:extLst>
              </a:tr>
              <a:tr h="253341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C 36:3 (PC 16:0_20:3) (2)</a:t>
                      </a:r>
                    </a:p>
                  </a:txBody>
                  <a:tcPr marL="6155" marR="6155" marT="61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0.753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50</a:t>
                      </a:r>
                    </a:p>
                  </a:txBody>
                  <a:tcPr marL="6155" marR="6155" marT="615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207216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5ED9C08F-578F-DF9A-E4AE-857B9F6D5BD5}"/>
              </a:ext>
            </a:extLst>
          </p:cNvPr>
          <p:cNvSpPr txBox="1"/>
          <p:nvPr/>
        </p:nvSpPr>
        <p:spPr>
          <a:xfrm>
            <a:off x="1156217" y="2204274"/>
            <a:ext cx="8138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E9C640A-18F1-1A57-10BB-59B0D965D2A5}"/>
              </a:ext>
            </a:extLst>
          </p:cNvPr>
          <p:cNvSpPr txBox="1"/>
          <p:nvPr/>
        </p:nvSpPr>
        <p:spPr>
          <a:xfrm>
            <a:off x="1156216" y="6500966"/>
            <a:ext cx="8138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BF71D5-4D28-562B-E649-6FB0C3BFCDE3}"/>
              </a:ext>
            </a:extLst>
          </p:cNvPr>
          <p:cNvSpPr txBox="1"/>
          <p:nvPr/>
        </p:nvSpPr>
        <p:spPr>
          <a:xfrm>
            <a:off x="3393831" y="316357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6C9B4C6-35FB-4380-CE01-51AD73092AA4}"/>
              </a:ext>
            </a:extLst>
          </p:cNvPr>
          <p:cNvSpPr txBox="1"/>
          <p:nvPr/>
        </p:nvSpPr>
        <p:spPr>
          <a:xfrm>
            <a:off x="14694757" y="316357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5C1B83C-FADD-8F42-9379-710D089C8C9A}"/>
              </a:ext>
            </a:extLst>
          </p:cNvPr>
          <p:cNvSpPr txBox="1"/>
          <p:nvPr/>
        </p:nvSpPr>
        <p:spPr>
          <a:xfrm>
            <a:off x="10755804" y="34055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*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627545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B6C0270C-9A83-4B90-8381-84EBE34239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9011205"/>
              </p:ext>
            </p:extLst>
          </p:nvPr>
        </p:nvGraphicFramePr>
        <p:xfrm>
          <a:off x="699247" y="1959652"/>
          <a:ext cx="17024337" cy="10258602"/>
        </p:xfrm>
        <a:graphic>
          <a:graphicData uri="http://schemas.openxmlformats.org/drawingml/2006/table">
            <a:tbl>
              <a:tblPr/>
              <a:tblGrid>
                <a:gridCol w="2117606">
                  <a:extLst>
                    <a:ext uri="{9D8B030D-6E8A-4147-A177-3AD203B41FA5}">
                      <a16:colId xmlns:a16="http://schemas.microsoft.com/office/drawing/2014/main" val="2435114418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875287543"/>
                    </a:ext>
                  </a:extLst>
                </a:gridCol>
                <a:gridCol w="744308">
                  <a:extLst>
                    <a:ext uri="{9D8B030D-6E8A-4147-A177-3AD203B41FA5}">
                      <a16:colId xmlns:a16="http://schemas.microsoft.com/office/drawing/2014/main" val="3509773818"/>
                    </a:ext>
                  </a:extLst>
                </a:gridCol>
                <a:gridCol w="964453">
                  <a:extLst>
                    <a:ext uri="{9D8B030D-6E8A-4147-A177-3AD203B41FA5}">
                      <a16:colId xmlns:a16="http://schemas.microsoft.com/office/drawing/2014/main" val="2157433236"/>
                    </a:ext>
                  </a:extLst>
                </a:gridCol>
                <a:gridCol w="754790">
                  <a:extLst>
                    <a:ext uri="{9D8B030D-6E8A-4147-A177-3AD203B41FA5}">
                      <a16:colId xmlns:a16="http://schemas.microsoft.com/office/drawing/2014/main" val="1330282978"/>
                    </a:ext>
                  </a:extLst>
                </a:gridCol>
                <a:gridCol w="2190988">
                  <a:extLst>
                    <a:ext uri="{9D8B030D-6E8A-4147-A177-3AD203B41FA5}">
                      <a16:colId xmlns:a16="http://schemas.microsoft.com/office/drawing/2014/main" val="3790876631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2471294706"/>
                    </a:ext>
                  </a:extLst>
                </a:gridCol>
                <a:gridCol w="744308">
                  <a:extLst>
                    <a:ext uri="{9D8B030D-6E8A-4147-A177-3AD203B41FA5}">
                      <a16:colId xmlns:a16="http://schemas.microsoft.com/office/drawing/2014/main" val="485906642"/>
                    </a:ext>
                  </a:extLst>
                </a:gridCol>
                <a:gridCol w="964453">
                  <a:extLst>
                    <a:ext uri="{9D8B030D-6E8A-4147-A177-3AD203B41FA5}">
                      <a16:colId xmlns:a16="http://schemas.microsoft.com/office/drawing/2014/main" val="4097607762"/>
                    </a:ext>
                  </a:extLst>
                </a:gridCol>
                <a:gridCol w="754790">
                  <a:extLst>
                    <a:ext uri="{9D8B030D-6E8A-4147-A177-3AD203B41FA5}">
                      <a16:colId xmlns:a16="http://schemas.microsoft.com/office/drawing/2014/main" val="2141646217"/>
                    </a:ext>
                  </a:extLst>
                </a:gridCol>
                <a:gridCol w="2190988">
                  <a:extLst>
                    <a:ext uri="{9D8B030D-6E8A-4147-A177-3AD203B41FA5}">
                      <a16:colId xmlns:a16="http://schemas.microsoft.com/office/drawing/2014/main" val="2207665609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1820211627"/>
                    </a:ext>
                  </a:extLst>
                </a:gridCol>
                <a:gridCol w="745200">
                  <a:extLst>
                    <a:ext uri="{9D8B030D-6E8A-4147-A177-3AD203B41FA5}">
                      <a16:colId xmlns:a16="http://schemas.microsoft.com/office/drawing/2014/main" val="1206175685"/>
                    </a:ext>
                  </a:extLst>
                </a:gridCol>
                <a:gridCol w="964453">
                  <a:extLst>
                    <a:ext uri="{9D8B030D-6E8A-4147-A177-3AD203B41FA5}">
                      <a16:colId xmlns:a16="http://schemas.microsoft.com/office/drawing/2014/main" val="3950529536"/>
                    </a:ext>
                  </a:extLst>
                </a:gridCol>
              </a:tblGrid>
              <a:tr h="293884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C vs B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C vs D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C vs B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5652407"/>
                  </a:ext>
                </a:extLst>
              </a:tr>
              <a:tr h="39184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ou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ou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ou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7185192"/>
                  </a:ext>
                </a:extLst>
              </a:tr>
              <a:tr h="39184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nn-Whitne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un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D/H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nn-Whitne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un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C/H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nn-Whitne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un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D/D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0713439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 (2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1E-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8E-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3.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4279982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 (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1E-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6E-0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9.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4939934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3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8E-0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6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1822836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poxanth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53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50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098409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rehal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2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3099418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phigosine 1-phosphat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562523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denosine-5-monophosphat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-monosteari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944820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 (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24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3.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almitole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l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3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8461803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 (2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18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6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1.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4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hreito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4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831425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3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c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9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8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2806773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poxanth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6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7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4;2O (3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1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9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T 24:1;O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9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1911479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phigosine 1-phosphat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7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9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alacton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3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xFA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18:1;(2OH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8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773418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5:4;2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6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xFA 18:0;(2OH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0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303332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tamat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7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o-inosito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50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0;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4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190154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8: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0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16:0 (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6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ys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658954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4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0;2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3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sparag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277707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ycol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8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itr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2;2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0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4947054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yrophosphat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16:0 (2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1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-monopalmiti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1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031735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c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20:4 (2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2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22: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6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4375569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0;2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4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henylacet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0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5:4;2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2122223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henylalan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0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20:4 (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largon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5118719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xoprol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sparag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uccin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6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131403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20: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xFA 18:1;(2OH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9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0 (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3453148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o-inosito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2 (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0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4;2O (3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7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7102233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itr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67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76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0;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60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alicylaldehyd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1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093226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8: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ys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ctadecano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4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3077150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ruct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2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0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18: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3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xal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6141534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4;2O (PE 20:4_18:0;2O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2;2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0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denosine-5-monophosphat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1106929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gat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20: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yrrole-2-carboxylic aci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5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4753799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hreito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8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16: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8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 (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1395751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yl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1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17: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yruvat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0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7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8943787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lin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 (2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460145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18: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4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021548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22: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1611992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gat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2779298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ruct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0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5471096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hreito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20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49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4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7714225"/>
                  </a:ext>
                </a:extLst>
              </a:tr>
              <a:tr h="2416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ylos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8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2031046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7088EAD-0521-4099-BFEE-95C245B92F97}"/>
              </a:ext>
            </a:extLst>
          </p:cNvPr>
          <p:cNvSpPr txBox="1"/>
          <p:nvPr/>
        </p:nvSpPr>
        <p:spPr>
          <a:xfrm>
            <a:off x="699247" y="381734"/>
            <a:ext cx="1665858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>
                <a:latin typeface="Arial" panose="020B0604020202020204" pitchFamily="34" charset="0"/>
                <a:cs typeface="Arial" panose="020B0604020202020204" pitchFamily="34" charset="0"/>
              </a:rPr>
              <a:t>(Supplement table 1) The list of plasma compounds that present the significant differences between groups</a:t>
            </a:r>
            <a:br>
              <a:rPr lang="en-US" altLang="ko-KR" sz="2400" b="1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altLang="ko-KR" sz="24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p-value was calculated using Mann-Whitney test and Dunn test with benjamini hochberg correction.</a:t>
            </a:r>
          </a:p>
        </p:txBody>
      </p:sp>
    </p:spTree>
    <p:extLst>
      <p:ext uri="{BB962C8B-B14F-4D97-AF65-F5344CB8AC3E}">
        <p14:creationId xmlns:p14="http://schemas.microsoft.com/office/powerpoint/2010/main" val="33083198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2FD83E30-FEAE-4E22-B189-13C18C440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0488834"/>
              </p:ext>
            </p:extLst>
          </p:nvPr>
        </p:nvGraphicFramePr>
        <p:xfrm>
          <a:off x="913606" y="1860551"/>
          <a:ext cx="16173450" cy="10349324"/>
        </p:xfrm>
        <a:graphic>
          <a:graphicData uri="http://schemas.openxmlformats.org/drawingml/2006/table">
            <a:tbl>
              <a:tblPr/>
              <a:tblGrid>
                <a:gridCol w="2049585">
                  <a:extLst>
                    <a:ext uri="{9D8B030D-6E8A-4147-A177-3AD203B41FA5}">
                      <a16:colId xmlns:a16="http://schemas.microsoft.com/office/drawing/2014/main" val="430529187"/>
                    </a:ext>
                  </a:extLst>
                </a:gridCol>
                <a:gridCol w="1359624">
                  <a:extLst>
                    <a:ext uri="{9D8B030D-6E8A-4147-A177-3AD203B41FA5}">
                      <a16:colId xmlns:a16="http://schemas.microsoft.com/office/drawing/2014/main" val="975063929"/>
                    </a:ext>
                  </a:extLst>
                </a:gridCol>
                <a:gridCol w="720398">
                  <a:extLst>
                    <a:ext uri="{9D8B030D-6E8A-4147-A177-3AD203B41FA5}">
                      <a16:colId xmlns:a16="http://schemas.microsoft.com/office/drawing/2014/main" val="3900596272"/>
                    </a:ext>
                  </a:extLst>
                </a:gridCol>
                <a:gridCol w="933473">
                  <a:extLst>
                    <a:ext uri="{9D8B030D-6E8A-4147-A177-3AD203B41FA5}">
                      <a16:colId xmlns:a16="http://schemas.microsoft.com/office/drawing/2014/main" val="2970169293"/>
                    </a:ext>
                  </a:extLst>
                </a:gridCol>
                <a:gridCol w="730545">
                  <a:extLst>
                    <a:ext uri="{9D8B030D-6E8A-4147-A177-3AD203B41FA5}">
                      <a16:colId xmlns:a16="http://schemas.microsoft.com/office/drawing/2014/main" val="1361817600"/>
                    </a:ext>
                  </a:extLst>
                </a:gridCol>
                <a:gridCol w="2120611">
                  <a:extLst>
                    <a:ext uri="{9D8B030D-6E8A-4147-A177-3AD203B41FA5}">
                      <a16:colId xmlns:a16="http://schemas.microsoft.com/office/drawing/2014/main" val="113073049"/>
                    </a:ext>
                  </a:extLst>
                </a:gridCol>
                <a:gridCol w="1359624">
                  <a:extLst>
                    <a:ext uri="{9D8B030D-6E8A-4147-A177-3AD203B41FA5}">
                      <a16:colId xmlns:a16="http://schemas.microsoft.com/office/drawing/2014/main" val="288499884"/>
                    </a:ext>
                  </a:extLst>
                </a:gridCol>
                <a:gridCol w="720398">
                  <a:extLst>
                    <a:ext uri="{9D8B030D-6E8A-4147-A177-3AD203B41FA5}">
                      <a16:colId xmlns:a16="http://schemas.microsoft.com/office/drawing/2014/main" val="3652094986"/>
                    </a:ext>
                  </a:extLst>
                </a:gridCol>
                <a:gridCol w="933473">
                  <a:extLst>
                    <a:ext uri="{9D8B030D-6E8A-4147-A177-3AD203B41FA5}">
                      <a16:colId xmlns:a16="http://schemas.microsoft.com/office/drawing/2014/main" val="3575513055"/>
                    </a:ext>
                  </a:extLst>
                </a:gridCol>
                <a:gridCol w="730545">
                  <a:extLst>
                    <a:ext uri="{9D8B030D-6E8A-4147-A177-3AD203B41FA5}">
                      <a16:colId xmlns:a16="http://schemas.microsoft.com/office/drawing/2014/main" val="3488684617"/>
                    </a:ext>
                  </a:extLst>
                </a:gridCol>
                <a:gridCol w="2120611">
                  <a:extLst>
                    <a:ext uri="{9D8B030D-6E8A-4147-A177-3AD203B41FA5}">
                      <a16:colId xmlns:a16="http://schemas.microsoft.com/office/drawing/2014/main" val="2507937858"/>
                    </a:ext>
                  </a:extLst>
                </a:gridCol>
                <a:gridCol w="730545">
                  <a:extLst>
                    <a:ext uri="{9D8B030D-6E8A-4147-A177-3AD203B41FA5}">
                      <a16:colId xmlns:a16="http://schemas.microsoft.com/office/drawing/2014/main" val="590728211"/>
                    </a:ext>
                  </a:extLst>
                </a:gridCol>
                <a:gridCol w="730545">
                  <a:extLst>
                    <a:ext uri="{9D8B030D-6E8A-4147-A177-3AD203B41FA5}">
                      <a16:colId xmlns:a16="http://schemas.microsoft.com/office/drawing/2014/main" val="2911229030"/>
                    </a:ext>
                  </a:extLst>
                </a:gridCol>
                <a:gridCol w="933473">
                  <a:extLst>
                    <a:ext uri="{9D8B030D-6E8A-4147-A177-3AD203B41FA5}">
                      <a16:colId xmlns:a16="http://schemas.microsoft.com/office/drawing/2014/main" val="3469673845"/>
                    </a:ext>
                  </a:extLst>
                </a:gridCol>
              </a:tblGrid>
              <a:tr h="117849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C vs B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C vs D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C vs B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3650158"/>
                  </a:ext>
                </a:extLst>
              </a:tr>
              <a:tr h="11272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ou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ou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ou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8503622"/>
                  </a:ext>
                </a:extLst>
              </a:tr>
              <a:tr h="16396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nn-Whitne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un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D/H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nn-Whitne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un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C/H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nn-Whitne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un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D/D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455383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6:2;O|PE 18:2_18:0;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0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3.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1731900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4 (PE 18:0_20:4)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1.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994204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42: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7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6973895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5;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1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65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2224989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4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10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86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8253728"/>
                  </a:ext>
                </a:extLst>
              </a:tr>
              <a:tr h="16396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3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05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6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2186419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6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20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7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8871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1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72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5848600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5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4469877"/>
                  </a:ext>
                </a:extLst>
              </a:tr>
              <a:tr h="225749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5;2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3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4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288160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5;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99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1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731413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phingosine 1-phosphat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xCer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34:1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965204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3;4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2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4 (PE 18:0_20:4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860152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3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42:7;O (PE 20:4_22:3;O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5061541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40:5;O (PE 22:4_18:1;O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0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M 36:1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056168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3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6:2 (PE 18:0_18:2)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9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870703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5;2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8:4 (PE O-18:0_20: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0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8485760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A 38:4 (PA 18:0_20: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4;2O (PE 20:4_18:0;2O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714332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5;3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9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O-38:6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6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31276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9:7 (PE O-17:1_22:6)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9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9:7 (PE O-17:1_22:6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8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376117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39: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9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O-31: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0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9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9261385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7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I 38:3 (PI 18:0_20:3) (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8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105659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6:0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0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I 37:4 (PI 17:0_20: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7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22827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6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4:3 (PE O-16:1_18:2)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4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004285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1;2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E 7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8883806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 81:16 (CL 17:2_22:4_20:5_22: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0.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 29:2;O;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1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 81:16 (CL 17:2_22:4_20:5_22: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142321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4 (PE 18:0_20:4)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1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4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9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2:5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7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3101119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42: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40:7 (PE O-18:2_22: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5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0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668650"/>
                  </a:ext>
                </a:extLst>
              </a:tr>
              <a:tr h="1639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35:6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1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G 18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8:2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0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786502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6:2;2O (PE 18:2_18:0;2O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5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3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7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30771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6:0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3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8: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2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0:4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660160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O-32:1 (PC O-16:0_16: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9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5:3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0: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9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6536288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MPE 34:2 (DMPE 16:0_18: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7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8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0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G 18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3471250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-Imidazoleacrylic aci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8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4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8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44: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6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3802525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-Cer 37:9;3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4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8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2428579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5:3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8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6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5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5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8627726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6:2;O (PE 18:1_18:1;O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1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0:1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8: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781820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6:2 (PE 18:0_18: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6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G 36:3 (PG 18:1_18:2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8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932636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4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0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2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6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7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776031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9:0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4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5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3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7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115120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O-35:5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0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8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5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7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465712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8: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8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4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1;2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7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54452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0:1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8: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I 38:5|PI 18:1_20:4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0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7792650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5:0/0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0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9:0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2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phingosine 1-phosphat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2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535015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8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5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9:0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6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6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6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2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59751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6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6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5:0/0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0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14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1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023613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0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3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6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3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993035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E 7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0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3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04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M 34:2;3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0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6715041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 80:1 (CL 18:0_18:0_26:0_18: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8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9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3;3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5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056498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NAPE 38:5 (NAPE 20:4/N-18: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6:0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T 27:1;O;S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8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120444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E 12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3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65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xFA 18:0;(2O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3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6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9057629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3 (PE 18:0_20:3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-Cer 37:9;3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G 36:3 (PG 18:1_18:2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3242778"/>
                  </a:ext>
                </a:extLst>
              </a:tr>
              <a:tr h="16396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7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3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5;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9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0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080825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8: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40:5;O (PE 22:4_18:1;O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0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5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9431526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0: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3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5;3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7519113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7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9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3;4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1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5645331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9:5;2O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7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3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5561862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8:0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G 40:7 (PG 18:1_22:6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5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1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188028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5: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1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0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4243606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 6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4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6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9752938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I 37:4|PI 17:0_20: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8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9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5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3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9534425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8:4 (PE O-18:1_20:3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5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4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4;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1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7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1694915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E 12: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6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11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4:3 (PE O-16:1_18:2)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8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6967275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M 40:2;2O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7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5;2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5E-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1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5731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5;O (PE 20:4_18:1;O)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2:5;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39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7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4037031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I 38:3 (PI 18:0_20:3) (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20:4;O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89E-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04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038801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40:6 (PE O-18:1_22:5)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45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275201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M 42:3;2O (SM 18:1;2O/24:2)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7934806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8:4 (PE O-18:1_20:3) (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5E-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689396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8:4 (PE O-18:0_20: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0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872916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42:7;O (PE 20:4_22:3;O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3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8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2162590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xCer 34:1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8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8288996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40:9 (PE O-18:3_22: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3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206220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3 (PE 18:0_20:3) (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22E-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6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837394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M 36:1;2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2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242127"/>
                  </a:ext>
                </a:extLst>
              </a:tr>
              <a:tr h="11272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8:3 (PE 18:0_20:3) (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4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3811640"/>
                  </a:ext>
                </a:extLst>
              </a:tr>
              <a:tr h="117849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I 38:4 (PI 18:0_20:4) (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09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1E-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5887262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59984DF3-278E-41DB-A9A4-85E8471A58B6}"/>
              </a:ext>
            </a:extLst>
          </p:cNvPr>
          <p:cNvSpPr txBox="1"/>
          <p:nvPr/>
        </p:nvSpPr>
        <p:spPr>
          <a:xfrm>
            <a:off x="699247" y="381734"/>
            <a:ext cx="1665858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>
                <a:latin typeface="Arial" panose="020B0604020202020204" pitchFamily="34" charset="0"/>
                <a:cs typeface="Arial" panose="020B0604020202020204" pitchFamily="34" charset="0"/>
              </a:rPr>
              <a:t>(Supplement table 2) The list of PBMC lipids with significant changes between BD, HC, and DC</a:t>
            </a: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sz="24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p-value was calculated using Mann-Whitney test and Dunn test with benjamini hochberg correction.</a:t>
            </a:r>
          </a:p>
        </p:txBody>
      </p:sp>
    </p:spTree>
    <p:extLst>
      <p:ext uri="{BB962C8B-B14F-4D97-AF65-F5344CB8AC3E}">
        <p14:creationId xmlns:p14="http://schemas.microsoft.com/office/powerpoint/2010/main" val="23542027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8983CA53-D2A9-46E9-9EB4-E1C8C834A7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8123343"/>
              </p:ext>
            </p:extLst>
          </p:nvPr>
        </p:nvGraphicFramePr>
        <p:xfrm>
          <a:off x="4577006" y="2231443"/>
          <a:ext cx="9964614" cy="8172000"/>
        </p:xfrm>
        <a:graphic>
          <a:graphicData uri="http://schemas.openxmlformats.org/drawingml/2006/table">
            <a:tbl>
              <a:tblPr/>
              <a:tblGrid>
                <a:gridCol w="1356104">
                  <a:extLst>
                    <a:ext uri="{9D8B030D-6E8A-4147-A177-3AD203B41FA5}">
                      <a16:colId xmlns:a16="http://schemas.microsoft.com/office/drawing/2014/main" val="3716413038"/>
                    </a:ext>
                  </a:extLst>
                </a:gridCol>
                <a:gridCol w="1521035">
                  <a:extLst>
                    <a:ext uri="{9D8B030D-6E8A-4147-A177-3AD203B41FA5}">
                      <a16:colId xmlns:a16="http://schemas.microsoft.com/office/drawing/2014/main" val="316630660"/>
                    </a:ext>
                  </a:extLst>
                </a:gridCol>
                <a:gridCol w="1667642">
                  <a:extLst>
                    <a:ext uri="{9D8B030D-6E8A-4147-A177-3AD203B41FA5}">
                      <a16:colId xmlns:a16="http://schemas.microsoft.com/office/drawing/2014/main" val="2021065316"/>
                    </a:ext>
                  </a:extLst>
                </a:gridCol>
                <a:gridCol w="1356104">
                  <a:extLst>
                    <a:ext uri="{9D8B030D-6E8A-4147-A177-3AD203B41FA5}">
                      <a16:colId xmlns:a16="http://schemas.microsoft.com/office/drawing/2014/main" val="2862252228"/>
                    </a:ext>
                  </a:extLst>
                </a:gridCol>
                <a:gridCol w="1360684">
                  <a:extLst>
                    <a:ext uri="{9D8B030D-6E8A-4147-A177-3AD203B41FA5}">
                      <a16:colId xmlns:a16="http://schemas.microsoft.com/office/drawing/2014/main" val="3902264900"/>
                    </a:ext>
                  </a:extLst>
                </a:gridCol>
                <a:gridCol w="1356104">
                  <a:extLst>
                    <a:ext uri="{9D8B030D-6E8A-4147-A177-3AD203B41FA5}">
                      <a16:colId xmlns:a16="http://schemas.microsoft.com/office/drawing/2014/main" val="2607852708"/>
                    </a:ext>
                  </a:extLst>
                </a:gridCol>
                <a:gridCol w="1346941">
                  <a:extLst>
                    <a:ext uri="{9D8B030D-6E8A-4147-A177-3AD203B41FA5}">
                      <a16:colId xmlns:a16="http://schemas.microsoft.com/office/drawing/2014/main" val="458076604"/>
                    </a:ext>
                  </a:extLst>
                </a:gridCol>
              </a:tblGrid>
              <a:tr h="396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egulation</a:t>
                      </a:r>
                    </a:p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in B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ntology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mpoun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lasm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BMC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7784863"/>
                  </a:ext>
                </a:extLst>
              </a:tr>
              <a:tr h="936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old change</a:t>
                      </a:r>
                      <a:b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</a:br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(BD/HC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old change</a:t>
                      </a:r>
                      <a:b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</a:br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(BD/HC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2895846"/>
                  </a:ext>
                </a:extLst>
              </a:tr>
              <a:tr h="360000">
                <a:tc rowSpan="17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Up-</a:t>
                      </a:r>
                      <a:b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</a:br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egul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EtherLP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PE O-16: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3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27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043649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PE O-18: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3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3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2095435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PE O-18: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3300311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phingolipi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1P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9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97039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5: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7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4310842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6: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7113555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8: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7</a:t>
                      </a:r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4174212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3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1200698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xF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6:4;2O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3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4121608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4926184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9</a:t>
                      </a:r>
                      <a:endParaRPr lang="en-US" altLang="ko-KR" sz="16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1680027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7068471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63039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20:4;2O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3.9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1746269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1.6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2283583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20:4;3O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.0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2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7203728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5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309082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xFA 18:0;(2OH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2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2701301"/>
                  </a:ext>
                </a:extLst>
              </a:tr>
              <a:tr h="3600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own-</a:t>
                      </a:r>
                      <a:b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</a:br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egul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xF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A 18:2;2O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157629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P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PE 22: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7427867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1874922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8F92103D-62C8-4CEC-949B-97EC47D0D04C}"/>
              </a:ext>
            </a:extLst>
          </p:cNvPr>
          <p:cNvSpPr txBox="1"/>
          <p:nvPr/>
        </p:nvSpPr>
        <p:spPr>
          <a:xfrm>
            <a:off x="699247" y="381734"/>
            <a:ext cx="1665858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Supplement table 3) Common features in plasma and PBMC</a:t>
            </a: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sz="24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-value was calculated using Mann-Whitney test.</a:t>
            </a:r>
          </a:p>
        </p:txBody>
      </p:sp>
    </p:spTree>
    <p:extLst>
      <p:ext uri="{BB962C8B-B14F-4D97-AF65-F5344CB8AC3E}">
        <p14:creationId xmlns:p14="http://schemas.microsoft.com/office/powerpoint/2010/main" val="29280046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DA770DE-E8F5-8305-AFA6-2851ED7D4942}"/>
              </a:ext>
            </a:extLst>
          </p:cNvPr>
          <p:cNvSpPr txBox="1"/>
          <p:nvPr/>
        </p:nvSpPr>
        <p:spPr>
          <a:xfrm>
            <a:off x="699247" y="381734"/>
            <a:ext cx="16658587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Supplement table 4) The evaluation confounding effect of clinical phenotype in inactive and active groups</a:t>
            </a:r>
          </a:p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b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he difference in distribution of clinical phenotype was tested by Fisher’s exact test (inactive group vs active group). The partial correlation analysis captured the feature that showed disease status-specific alteration after adjusting the uveitis. The pattern of features is pre-determined by numeric order to the relative abundance (healthy control – inactive – active). </a:t>
            </a:r>
          </a:p>
        </p:txBody>
      </p:sp>
      <p:graphicFrame>
        <p:nvGraphicFramePr>
          <p:cNvPr id="9" name="표 8">
            <a:extLst>
              <a:ext uri="{FF2B5EF4-FFF2-40B4-BE49-F238E27FC236}">
                <a16:creationId xmlns:a16="http://schemas.microsoft.com/office/drawing/2014/main" id="{E9DC929F-7073-0A8D-09DF-279CD0F444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927946"/>
              </p:ext>
            </p:extLst>
          </p:nvPr>
        </p:nvGraphicFramePr>
        <p:xfrm>
          <a:off x="2736363" y="2523615"/>
          <a:ext cx="12584353" cy="8606730"/>
        </p:xfrm>
        <a:graphic>
          <a:graphicData uri="http://schemas.openxmlformats.org/drawingml/2006/table">
            <a:tbl>
              <a:tblPr/>
              <a:tblGrid>
                <a:gridCol w="2154123">
                  <a:extLst>
                    <a:ext uri="{9D8B030D-6E8A-4147-A177-3AD203B41FA5}">
                      <a16:colId xmlns:a16="http://schemas.microsoft.com/office/drawing/2014/main" val="1875955628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2299976163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1078728056"/>
                    </a:ext>
                  </a:extLst>
                </a:gridCol>
                <a:gridCol w="3698230">
                  <a:extLst>
                    <a:ext uri="{9D8B030D-6E8A-4147-A177-3AD203B41FA5}">
                      <a16:colId xmlns:a16="http://schemas.microsoft.com/office/drawing/2014/main" val="3958021213"/>
                    </a:ext>
                  </a:extLst>
                </a:gridCol>
                <a:gridCol w="1404000">
                  <a:extLst>
                    <a:ext uri="{9D8B030D-6E8A-4147-A177-3AD203B41FA5}">
                      <a16:colId xmlns:a16="http://schemas.microsoft.com/office/drawing/2014/main" val="2710871933"/>
                    </a:ext>
                  </a:extLst>
                </a:gridCol>
                <a:gridCol w="1404000">
                  <a:extLst>
                    <a:ext uri="{9D8B030D-6E8A-4147-A177-3AD203B41FA5}">
                      <a16:colId xmlns:a16="http://schemas.microsoft.com/office/drawing/2014/main" val="301467269"/>
                    </a:ext>
                  </a:extLst>
                </a:gridCol>
                <a:gridCol w="1404000">
                  <a:extLst>
                    <a:ext uri="{9D8B030D-6E8A-4147-A177-3AD203B41FA5}">
                      <a16:colId xmlns:a16="http://schemas.microsoft.com/office/drawing/2014/main" val="572249451"/>
                    </a:ext>
                  </a:extLst>
                </a:gridCol>
              </a:tblGrid>
              <a:tr h="648000"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isher's exact tes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artial correlation analysi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4286186"/>
                  </a:ext>
                </a:extLst>
              </a:tr>
              <a:tr h="2520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inical phenotyp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as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BM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ounds　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rrel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-sta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5001753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287318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ral aphthous ulcer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nb-NO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NAPE 38:5 (LNAPE 20:4/N-18: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0.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4.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60E-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9300931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enital ulcer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9:0 (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8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60E-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15007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kin les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5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E 16: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836639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Uveiti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0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E 7: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4039239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rthriti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 81:16 (CL 17:2_22:4_20:5_22: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0166627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I les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20:1 (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6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7137746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NS les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O-35:5 (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1467218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Vascular involve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69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1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6: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9047874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yslipidemi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8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9:0 (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2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5302179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A</a:t>
                      </a: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48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35:6 (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1801234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athergy tes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11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9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36:2 (PE 18:0_18:2) (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2222163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LA-B51 tes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1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MPE 34:2 (DMPE 16:0_18: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5950271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O-32:1 (PC O-16:0_16: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117703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8: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3667811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G 42:10 (PG 20:4_22:6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0060827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39:7 (PE O-17:1_22:6) (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2643388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C 14: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7460781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 O-40:6 (PE O-18:1_22:5) (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429914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A 16:0;2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3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27566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18:2 (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0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1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1884609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C 24: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0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569439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E O-18: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9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981976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1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0.29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23611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55336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024</TotalTime>
  <Words>3169</Words>
  <Application>Microsoft Office PowerPoint</Application>
  <PresentationFormat>사용자 지정</PresentationFormat>
  <Paragraphs>1575</Paragraphs>
  <Slides>8</Slides>
  <Notes>6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수진</dc:creator>
  <cp:lastModifiedBy>박수진</cp:lastModifiedBy>
  <cp:revision>73</cp:revision>
  <dcterms:created xsi:type="dcterms:W3CDTF">2021-05-10T05:06:54Z</dcterms:created>
  <dcterms:modified xsi:type="dcterms:W3CDTF">2022-12-24T16:52:41Z</dcterms:modified>
</cp:coreProperties>
</file>